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10CE177-ECB4-42C9-87C0-67AB1B8CA5DC}" v="1" dt="2021-09-28T14:30:49.1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7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2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1E8D713A-D82B-4018-844E-FF6439E2D0FB}"/>
    <pc:docChg chg="undo custSel addSld modSld">
      <pc:chgData name="Lois Hoyer" userId="8c378a1a5b622d94" providerId="LiveId" clId="{1E8D713A-D82B-4018-844E-FF6439E2D0FB}" dt="2021-09-21T16:17:38.929" v="1227" actId="20577"/>
      <pc:docMkLst>
        <pc:docMk/>
      </pc:docMkLst>
      <pc:sldChg chg="addSp delSp modSp mod">
        <pc:chgData name="Lois Hoyer" userId="8c378a1a5b622d94" providerId="LiveId" clId="{1E8D713A-D82B-4018-844E-FF6439E2D0FB}" dt="2021-09-21T14:28:52.852" v="1224" actId="1076"/>
        <pc:sldMkLst>
          <pc:docMk/>
          <pc:sldMk cId="380902020" sldId="256"/>
        </pc:sldMkLst>
        <pc:spChg chg="mod topLvl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4" creationId="{2647DDF4-759B-481A-ABF3-7AA8F7097C11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5" creationId="{64C3A0DE-2C91-4535-AF7A-394814E83416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6" creationId="{2C30B5B3-7C20-4A72-AE5A-16CC182652BF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7" creationId="{1788274D-7DAA-4CB4-B7FC-0D3AC7589C34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8" creationId="{3584E819-1072-44B5-AD29-2BC2E3E3F614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9" creationId="{0EA8121A-2563-4FAB-9306-905C2FBAE103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0" creationId="{671991C7-55BE-4B38-8499-4BC83CF330C2}"/>
          </ac:spMkLst>
        </pc:spChg>
        <pc:spChg chg="mod topLvl">
          <ac:chgData name="Lois Hoyer" userId="8c378a1a5b622d94" providerId="LiveId" clId="{1E8D713A-D82B-4018-844E-FF6439E2D0FB}" dt="2021-09-17T17:15:06.876" v="706" actId="164"/>
          <ac:spMkLst>
            <pc:docMk/>
            <pc:sldMk cId="380902020" sldId="256"/>
            <ac:spMk id="11" creationId="{C53B7DEB-0242-4DA1-AD1A-18B89AB23B1B}"/>
          </ac:spMkLst>
        </pc:spChg>
        <pc:spChg chg="mod topLvl">
          <ac:chgData name="Lois Hoyer" userId="8c378a1a5b622d94" providerId="LiveId" clId="{1E8D713A-D82B-4018-844E-FF6439E2D0FB}" dt="2021-09-17T17:15:06.876" v="706" actId="164"/>
          <ac:spMkLst>
            <pc:docMk/>
            <pc:sldMk cId="380902020" sldId="256"/>
            <ac:spMk id="12" creationId="{17A22548-54DF-40F4-84DC-95AB081A9103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3" creationId="{57EC84E6-98DA-45C6-8227-41F49A2CD02A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4" creationId="{DFD0AC64-0912-458A-B668-81CE91F1BF25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5" creationId="{14076AB1-52D6-41EC-ACB9-9146159F994F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6" creationId="{26159DAA-3378-4CFD-B48B-4085884F2CA5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7" creationId="{8B6CEA89-DEA2-4B7D-852D-630D11CF0599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8" creationId="{2B03AF00-5801-4B5C-9D1A-9B510178875B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9" creationId="{8ED943C0-4F00-4CE1-8CE0-E8D84A631131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0" creationId="{B6234098-4491-4151-8F6D-6566CCD8E1EF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1" creationId="{CF4C54DE-4B3F-4AC3-AB9C-C14045395109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2" creationId="{8AB1D928-8435-4347-AA6F-5EAD0778F64F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3" creationId="{AE88B02D-1F58-4D12-9B2F-104DE09B04E1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4" creationId="{2C365E4A-95A8-458B-A2ED-9C4B6A172947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5" creationId="{674B89E5-5CA4-44B1-925B-516FC21D429F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6" creationId="{DCD11C46-4AD5-4580-B4DA-978CCC459D5A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7" creationId="{02795E41-B6F1-4E3F-B02D-BA18EC34DE78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8" creationId="{35E50ACA-C8DC-408A-9A4F-E42555A36035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29" creationId="{F0C53207-1C06-4CAF-9368-D198DD1B2D26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0" creationId="{2A64D5B1-0F40-4700-BB87-3277C3CC7364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1" creationId="{E545F580-95A5-4DA5-9676-9FEBAE0444BC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2" creationId="{E927BF54-6C30-460E-A4F0-208CDB67FE9E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3" creationId="{0A015689-3468-4E81-A48D-555E51C647F9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4" creationId="{5581D6BD-69D7-46ED-9B95-3B84806E3C35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5" creationId="{12D30921-7CB7-42A4-9256-404970B5B152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6" creationId="{5C807E02-4C81-4914-8CFA-988742247FA7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7" creationId="{B1B5C760-FD2D-4D15-ACFA-2025FB0FE91E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8" creationId="{4A25A915-E48D-4428-AD4D-9972145DC0DE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39" creationId="{57B92455-0D78-43CE-8803-F04E921A4F8A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0" creationId="{ED77AD38-6AF4-4219-A01E-E9B07CC1DA30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1" creationId="{4AFC4CA9-AD5F-472A-971A-1CA4B23C367E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2" creationId="{C7E7A64E-6CC6-47A2-8B58-EEDE52FE46A7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3" creationId="{5B806C55-6CAB-4C17-8C05-9B7D8EE20487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4" creationId="{E1F38D94-51CF-4B8F-82CF-B18F4A0FEA9A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5" creationId="{90D3B040-D604-43FD-9575-738BF018FB6E}"/>
          </ac:spMkLst>
        </pc:spChg>
        <pc:spChg chg="mod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46" creationId="{0E18AE9F-10C1-4E5E-A44D-72DE10AAB00D}"/>
          </ac:spMkLst>
        </pc:spChg>
        <pc:spChg chg="mod topLvl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47" creationId="{B2E83ED4-51E8-4843-9413-0A607B240438}"/>
          </ac:spMkLst>
        </pc:spChg>
        <pc:spChg chg="mod topLvl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48" creationId="{E1CC8FBC-C940-4F8C-8B1D-269BFBEAFAB5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49" creationId="{816331E3-6B3E-4988-B5ED-58D0F087754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0" creationId="{F8F2B976-4AE0-4D48-B594-8DF1973FFB2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1" creationId="{0BAED963-EA20-4AA5-BB2C-7D6D04A30C4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2" creationId="{851B09DB-0EE1-4757-B28A-266226E3369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3" creationId="{F619A7EB-4154-4B8D-9DBD-65AA491B3089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4" creationId="{C2F67B9D-1FD1-4AF6-9F41-51BDA8E02D83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5" creationId="{84B27E5B-4DB8-4C6D-8824-BF1DE52CD93C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6" creationId="{20511B62-BD14-4229-8F45-9C9379B13F6B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7" creationId="{96C20C2A-8C3A-49D6-8B27-28B5F54E57F0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8" creationId="{60D80F0D-1204-47FF-8213-3CC400B614C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59" creationId="{71C7E459-A645-4234-9D9C-88AF15417D0C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0" creationId="{26B8D77D-6694-49DE-B321-C04CB6BFAEFC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1" creationId="{8D648E33-59A1-4520-B546-50363BC0D7F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2" creationId="{96DEB5E0-377A-4404-B038-519D9CDE22B3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3" creationId="{0640907E-9269-4BF2-80F6-BB82EBF37CB1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4" creationId="{3302CAD9-271F-42EB-A600-7E6ED2CA0B47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5" creationId="{756B6C94-39A7-4DF0-BD89-C2B7485C3688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6" creationId="{434FB8AB-15AC-4792-94C1-B518E9EB2B97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7" creationId="{6579CA24-4D39-4D13-9052-1069B15BC590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8" creationId="{41F16969-6017-49A4-8D9F-AE691C6F0E6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69" creationId="{F687A96F-8DBB-4F0C-8A75-7210BECB58C0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0" creationId="{7C73FD2F-92A5-43E6-84E5-D555DDC8BDA2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1" creationId="{A0BA3036-A571-4CC6-8C1A-A6D46C347849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2" creationId="{25D4EAB3-4275-4CD7-8436-5847D853BF0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3" creationId="{E8B80CFE-6ADB-4B28-A55F-E206D28CFE6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4" creationId="{E8F6A316-E6F2-4B0D-B30C-6370938FA7F2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5" creationId="{A05CC0FD-DDE9-463C-868E-DCE16D963B6B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6" creationId="{260966ED-EA91-4993-AD3F-149069F4EBAA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7" creationId="{D928C57D-C42A-41A2-BF98-071C64A7286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8" creationId="{6933330D-4E50-4A3C-8E7A-233FB407868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79" creationId="{0E3D681E-AE3C-4251-ABC7-4511E4A2620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0" creationId="{2EED958C-125A-44D0-A8F6-F7A63AE0D8E3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1" creationId="{DE1AB3D8-0DC3-48C4-9A97-392F16653661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2" creationId="{9B167F42-ADE6-433E-9023-B58B4F15AB4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3" creationId="{01B73892-CE4B-491C-8703-971A718DFB4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4" creationId="{142C2008-48C7-4489-831D-D57D1A81E0CA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5" creationId="{D987FC38-AE6F-4ED7-A814-4FB1FDC23BC9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6" creationId="{7C10356F-A067-438C-871A-5A69FA251C75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7" creationId="{A82104CA-CA6F-4644-BEE3-B9D187CCE7D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8" creationId="{41AA6EFC-E493-4860-8FE6-504B0853E6F9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89" creationId="{C65A2AD6-32E1-4299-9C94-D1C21D3F3177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0" creationId="{1D416637-0704-4752-8F6C-9F11093F5B1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1" creationId="{6C305552-993E-4B1C-BE20-7B8FCE9BC2CD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2" creationId="{0A97F099-E052-4A52-8D14-946C5D91E1F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3" creationId="{7EE6519B-8DDE-4E16-8C85-0AD7D6A4C8D0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4" creationId="{E79F9B98-771F-40CA-BF41-9A788046639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5" creationId="{4E298672-0C5F-43C7-B012-9813D3B69742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6" creationId="{9DEE6D81-D2C4-4171-B9D2-260852A4F560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7" creationId="{98683610-F16C-40DF-A175-7F34B217B41C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8" creationId="{95E0C0D7-D2CE-47F9-9265-5D1365DDE21C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99" creationId="{91A81DE8-12E8-4A60-9897-3118C7272438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0" creationId="{667B24FF-C2EA-4A02-8C2C-3A08434470A7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1" creationId="{2880956F-F11E-4718-8A2F-83F9B33729D8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2" creationId="{7D555809-E7EC-4BAD-B7BD-D1DE75CF431A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3" creationId="{58140FE2-B576-4DD7-B2ED-F25B47B0AE22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4" creationId="{56D9121C-706B-4EFF-AD26-227683EFDAC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5" creationId="{A2AA0264-C7D1-4ACF-A221-282AA2F559EA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6" creationId="{2C123B1D-0338-43D4-BC45-69F34A39C84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7" creationId="{B3576BDC-C3F2-4F94-9E02-55386B72BCC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8" creationId="{1F7A20F3-362B-45B6-99B7-824996B6AC29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09" creationId="{11DDFB9B-845C-469C-8B0C-983E5CD6E2FE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10" creationId="{D0A22F11-304B-45B9-9CDF-F1917128620A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11" creationId="{B34DBF0E-4585-4834-9542-E3582A1123CF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12" creationId="{9D315F3E-64AF-4B9C-8E62-2D9DFEA212E6}"/>
          </ac:spMkLst>
        </pc:spChg>
        <pc:spChg chg="mod topLvl">
          <ac:chgData name="Lois Hoyer" userId="8c378a1a5b622d94" providerId="LiveId" clId="{1E8D713A-D82B-4018-844E-FF6439E2D0FB}" dt="2021-09-17T17:15:36.066" v="711" actId="338"/>
          <ac:spMkLst>
            <pc:docMk/>
            <pc:sldMk cId="380902020" sldId="256"/>
            <ac:spMk id="113" creationId="{94EF5E3A-26EF-47F2-B653-30947D82AD57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4" creationId="{7E0F1560-C29E-4073-9F75-68ACF0D10CE8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5" creationId="{A4120B7B-1062-48A4-92B0-A6B7DE0A752D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6" creationId="{84B325BC-23BA-42AC-A61B-F5BA8E08D919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7" creationId="{AD3045DA-26B3-416D-B589-425D37751EEF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8" creationId="{45FED51F-C253-4509-BE45-D5C169B53156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19" creationId="{A64CD0E0-ECF7-4C99-B223-47ED965E18F2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0" creationId="{BD5B035F-0678-4F40-91E5-D65C0342FA01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1" creationId="{4A7708C6-7334-4D20-AECE-8C59EAB423E8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2" creationId="{5A631DE6-4F56-485D-BDA2-89B41F74FC87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3" creationId="{77122AB3-B699-4E31-8495-4BBF6D32F44F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4" creationId="{3D6BAD10-97E9-45DE-8BBA-B3937CB27DD6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5" creationId="{9C6E7825-36E3-4C31-9FDF-7C6C07353111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26" creationId="{C76E54CF-1C0A-4456-BCF5-DB83573196F2}"/>
          </ac:spMkLst>
        </pc:spChg>
        <pc:spChg chg="del mod">
          <ac:chgData name="Lois Hoyer" userId="8c378a1a5b622d94" providerId="LiveId" clId="{1E8D713A-D82B-4018-844E-FF6439E2D0FB}" dt="2021-09-21T14:20:04.150" v="754" actId="21"/>
          <ac:spMkLst>
            <pc:docMk/>
            <pc:sldMk cId="380902020" sldId="256"/>
            <ac:spMk id="127" creationId="{9236DBB7-5FA7-4F53-8055-CE02AC8180F2}"/>
          </ac:spMkLst>
        </pc:spChg>
        <pc:spChg chg="mod topLvl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28" creationId="{824E47CC-CB90-4275-94FC-18A57D89BF2E}"/>
          </ac:spMkLst>
        </pc:spChg>
        <pc:spChg chg="mod topLvl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29" creationId="{57130DC9-C168-406B-A671-4A916B5EE5CF}"/>
          </ac:spMkLst>
        </pc:spChg>
        <pc:spChg chg="mod topLvl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30" creationId="{D6F8BF60-A1E7-43DB-B7B9-ABA883130456}"/>
          </ac:spMkLst>
        </pc:spChg>
        <pc:spChg chg="mod topLvl">
          <ac:chgData name="Lois Hoyer" userId="8c378a1a5b622d94" providerId="LiveId" clId="{1E8D713A-D82B-4018-844E-FF6439E2D0FB}" dt="2021-09-17T17:14:39.901" v="700" actId="165"/>
          <ac:spMkLst>
            <pc:docMk/>
            <pc:sldMk cId="380902020" sldId="256"/>
            <ac:spMk id="131" creationId="{87AB9E63-6A40-4ED1-B3AC-0A4639DEBB54}"/>
          </ac:spMkLst>
        </pc:spChg>
        <pc:spChg chg="mod">
          <ac:chgData name="Lois Hoyer" userId="8c378a1a5b622d94" providerId="LiveId" clId="{1E8D713A-D82B-4018-844E-FF6439E2D0FB}" dt="2021-08-31T18:55:54.968" v="148" actId="164"/>
          <ac:spMkLst>
            <pc:docMk/>
            <pc:sldMk cId="380902020" sldId="256"/>
            <ac:spMk id="132" creationId="{E2D503D4-FFBC-4F82-A622-5DE3F7798A70}"/>
          </ac:spMkLst>
        </pc:spChg>
        <pc:spChg chg="add mod">
          <ac:chgData name="Lois Hoyer" userId="8c378a1a5b622d94" providerId="LiveId" clId="{1E8D713A-D82B-4018-844E-FF6439E2D0FB}" dt="2021-09-21T14:28:17.589" v="1220" actId="1076"/>
          <ac:spMkLst>
            <pc:docMk/>
            <pc:sldMk cId="380902020" sldId="256"/>
            <ac:spMk id="134" creationId="{68E26761-2CBD-4EBB-8115-94E2B89A7467}"/>
          </ac:spMkLst>
        </pc:spChg>
        <pc:spChg chg="add mod">
          <ac:chgData name="Lois Hoyer" userId="8c378a1a5b622d94" providerId="LiveId" clId="{1E8D713A-D82B-4018-844E-FF6439E2D0FB}" dt="2021-09-21T14:28:43.784" v="1223" actId="1076"/>
          <ac:spMkLst>
            <pc:docMk/>
            <pc:sldMk cId="380902020" sldId="256"/>
            <ac:spMk id="144" creationId="{6AC2FB6D-977D-42BA-AF69-C5887A998588}"/>
          </ac:spMkLst>
        </pc:spChg>
        <pc:spChg chg="add mod">
          <ac:chgData name="Lois Hoyer" userId="8c378a1a5b622d94" providerId="LiveId" clId="{1E8D713A-D82B-4018-844E-FF6439E2D0FB}" dt="2021-09-21T14:28:25.903" v="1221" actId="1076"/>
          <ac:spMkLst>
            <pc:docMk/>
            <pc:sldMk cId="380902020" sldId="256"/>
            <ac:spMk id="145" creationId="{56603B88-69D2-4969-A0F8-CF996CB13C03}"/>
          </ac:spMkLst>
        </pc:spChg>
        <pc:spChg chg="add mod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146" creationId="{343FA6CB-8ADA-4EE9-966B-4ED1CF05BED0}"/>
          </ac:spMkLst>
        </pc:spChg>
        <pc:spChg chg="add mod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147" creationId="{4B9B9B2E-2062-4ED9-B18B-636503BF946B}"/>
          </ac:spMkLst>
        </pc:spChg>
        <pc:spChg chg="add mod">
          <ac:chgData name="Lois Hoyer" userId="8c378a1a5b622d94" providerId="LiveId" clId="{1E8D713A-D82B-4018-844E-FF6439E2D0FB}" dt="2021-09-17T17:17:13.177" v="744" actId="164"/>
          <ac:spMkLst>
            <pc:docMk/>
            <pc:sldMk cId="380902020" sldId="256"/>
            <ac:spMk id="148" creationId="{F670EB90-21AF-49E4-BB75-76209CADBF14}"/>
          </ac:spMkLst>
        </pc:spChg>
        <pc:spChg chg="add mod">
          <ac:chgData name="Lois Hoyer" userId="8c378a1a5b622d94" providerId="LiveId" clId="{1E8D713A-D82B-4018-844E-FF6439E2D0FB}" dt="2021-09-21T14:28:37.658" v="1222" actId="1076"/>
          <ac:spMkLst>
            <pc:docMk/>
            <pc:sldMk cId="380902020" sldId="256"/>
            <ac:spMk id="149" creationId="{DDD03CFE-9267-475E-B330-CBBA13875216}"/>
          </ac:spMkLst>
        </pc:spChg>
        <pc:spChg chg="add mod">
          <ac:chgData name="Lois Hoyer" userId="8c378a1a5b622d94" providerId="LiveId" clId="{1E8D713A-D82B-4018-844E-FF6439E2D0FB}" dt="2021-09-21T14:28:52.852" v="1224" actId="1076"/>
          <ac:spMkLst>
            <pc:docMk/>
            <pc:sldMk cId="380902020" sldId="256"/>
            <ac:spMk id="150" creationId="{3AC7763E-212E-42C6-B790-68DA6D9E8370}"/>
          </ac:spMkLst>
        </pc:spChg>
        <pc:spChg chg="add del mod">
          <ac:chgData name="Lois Hoyer" userId="8c378a1a5b622d94" providerId="LiveId" clId="{1E8D713A-D82B-4018-844E-FF6439E2D0FB}" dt="2021-09-21T14:26:52.276" v="1206" actId="478"/>
          <ac:spMkLst>
            <pc:docMk/>
            <pc:sldMk cId="380902020" sldId="256"/>
            <ac:spMk id="151" creationId="{ADCD20C5-A814-47B7-BD26-E846DE41BA91}"/>
          </ac:spMkLst>
        </pc:spChg>
        <pc:grpChg chg="add mod">
          <ac:chgData name="Lois Hoyer" userId="8c378a1a5b622d94" providerId="LiveId" clId="{1E8D713A-D82B-4018-844E-FF6439E2D0FB}" dt="2021-09-21T14:27:59.878" v="1215" actId="164"/>
          <ac:grpSpMkLst>
            <pc:docMk/>
            <pc:sldMk cId="380902020" sldId="256"/>
            <ac:grpSpMk id="2" creationId="{88A08B8A-1DBA-4335-A4FE-17230DFE4924}"/>
          </ac:grpSpMkLst>
        </pc:grpChg>
        <pc:grpChg chg="add mod">
          <ac:chgData name="Lois Hoyer" userId="8c378a1a5b622d94" providerId="LiveId" clId="{1E8D713A-D82B-4018-844E-FF6439E2D0FB}" dt="2021-09-17T17:17:13.177" v="744" actId="164"/>
          <ac:grpSpMkLst>
            <pc:docMk/>
            <pc:sldMk cId="380902020" sldId="256"/>
            <ac:grpSpMk id="3" creationId="{B4D63C2D-B052-4529-AAB5-F953D6A141A7}"/>
          </ac:grpSpMkLst>
        </pc:grpChg>
        <pc:grpChg chg="add mod topLvl">
          <ac:chgData name="Lois Hoyer" userId="8c378a1a5b622d94" providerId="LiveId" clId="{1E8D713A-D82B-4018-844E-FF6439E2D0FB}" dt="2021-09-17T17:17:13.177" v="744" actId="164"/>
          <ac:grpSpMkLst>
            <pc:docMk/>
            <pc:sldMk cId="380902020" sldId="256"/>
            <ac:grpSpMk id="133" creationId="{94263382-7985-4621-BE0B-1B6FA9ABC393}"/>
          </ac:grpSpMkLst>
        </pc:grpChg>
        <pc:grpChg chg="add del mod topLvl">
          <ac:chgData name="Lois Hoyer" userId="8c378a1a5b622d94" providerId="LiveId" clId="{1E8D713A-D82B-4018-844E-FF6439E2D0FB}" dt="2021-09-17T17:15:20.203" v="709" actId="165"/>
          <ac:grpSpMkLst>
            <pc:docMk/>
            <pc:sldMk cId="380902020" sldId="256"/>
            <ac:grpSpMk id="134" creationId="{9610969E-7A4C-45AB-8405-5BA146BDD319}"/>
          </ac:grpSpMkLst>
        </pc:grpChg>
        <pc:grpChg chg="add del mod topLvl">
          <ac:chgData name="Lois Hoyer" userId="8c378a1a5b622d94" providerId="LiveId" clId="{1E8D713A-D82B-4018-844E-FF6439E2D0FB}" dt="2021-08-31T18:56:43.588" v="154" actId="165"/>
          <ac:grpSpMkLst>
            <pc:docMk/>
            <pc:sldMk cId="380902020" sldId="256"/>
            <ac:grpSpMk id="135" creationId="{18B9ADDC-EB38-431C-B980-E52398119D84}"/>
          </ac:grpSpMkLst>
        </pc:grpChg>
        <pc:grpChg chg="add mod">
          <ac:chgData name="Lois Hoyer" userId="8c378a1a5b622d94" providerId="LiveId" clId="{1E8D713A-D82B-4018-844E-FF6439E2D0FB}" dt="2021-09-21T14:28:10.868" v="1218" actId="1076"/>
          <ac:grpSpMkLst>
            <pc:docMk/>
            <pc:sldMk cId="380902020" sldId="256"/>
            <ac:grpSpMk id="135" creationId="{F92614F8-4E71-4AF7-A765-238649C84897}"/>
          </ac:grpSpMkLst>
        </pc:grpChg>
        <pc:grpChg chg="add del mod topLvl">
          <ac:chgData name="Lois Hoyer" userId="8c378a1a5b622d94" providerId="LiveId" clId="{1E8D713A-D82B-4018-844E-FF6439E2D0FB}" dt="2021-09-17T17:14:45.860" v="702" actId="165"/>
          <ac:grpSpMkLst>
            <pc:docMk/>
            <pc:sldMk cId="380902020" sldId="256"/>
            <ac:grpSpMk id="136" creationId="{5FC6A1BE-C076-427E-B044-B090A59523BD}"/>
          </ac:grpSpMkLst>
        </pc:grpChg>
        <pc:grpChg chg="add mod">
          <ac:chgData name="Lois Hoyer" userId="8c378a1a5b622d94" providerId="LiveId" clId="{1E8D713A-D82B-4018-844E-FF6439E2D0FB}" dt="2021-09-21T14:28:14.400" v="1219" actId="1076"/>
          <ac:grpSpMkLst>
            <pc:docMk/>
            <pc:sldMk cId="380902020" sldId="256"/>
            <ac:grpSpMk id="136" creationId="{9F6DAB1B-76B4-4E48-B095-5A44A8251152}"/>
          </ac:grpSpMkLst>
        </pc:grpChg>
        <pc:grpChg chg="add del mod topLvl">
          <ac:chgData name="Lois Hoyer" userId="8c378a1a5b622d94" providerId="LiveId" clId="{1E8D713A-D82B-4018-844E-FF6439E2D0FB}" dt="2021-08-31T18:56:38.586" v="153" actId="165"/>
          <ac:grpSpMkLst>
            <pc:docMk/>
            <pc:sldMk cId="380902020" sldId="256"/>
            <ac:grpSpMk id="137" creationId="{1DAAA352-6E67-4E02-89D3-43FDD6654DB7}"/>
          </ac:grpSpMkLst>
        </pc:grpChg>
        <pc:grpChg chg="add del mod">
          <ac:chgData name="Lois Hoyer" userId="8c378a1a5b622d94" providerId="LiveId" clId="{1E8D713A-D82B-4018-844E-FF6439E2D0FB}" dt="2021-08-31T18:56:33.238" v="152" actId="165"/>
          <ac:grpSpMkLst>
            <pc:docMk/>
            <pc:sldMk cId="380902020" sldId="256"/>
            <ac:grpSpMk id="138" creationId="{92027BEA-ACB0-4822-9917-E8FA08FE10EC}"/>
          </ac:grpSpMkLst>
        </pc:grpChg>
        <pc:grpChg chg="add mod">
          <ac:chgData name="Lois Hoyer" userId="8c378a1a5b622d94" providerId="LiveId" clId="{1E8D713A-D82B-4018-844E-FF6439E2D0FB}" dt="2021-09-21T14:27:59.878" v="1215" actId="164"/>
          <ac:grpSpMkLst>
            <pc:docMk/>
            <pc:sldMk cId="380902020" sldId="256"/>
            <ac:grpSpMk id="139" creationId="{8ABA59C4-8339-4A46-87AC-865B0CF151E3}"/>
          </ac:grpSpMkLst>
        </pc:grpChg>
        <pc:grpChg chg="mod topLvl">
          <ac:chgData name="Lois Hoyer" userId="8c378a1a5b622d94" providerId="LiveId" clId="{1E8D713A-D82B-4018-844E-FF6439E2D0FB}" dt="2021-09-17T17:17:13.177" v="744" actId="164"/>
          <ac:grpSpMkLst>
            <pc:docMk/>
            <pc:sldMk cId="380902020" sldId="256"/>
            <ac:grpSpMk id="140" creationId="{B8C4411D-C052-4789-BD09-4AD130DE7BEA}"/>
          </ac:grpSpMkLst>
        </pc:grpChg>
        <pc:grpChg chg="del mod topLvl">
          <ac:chgData name="Lois Hoyer" userId="8c378a1a5b622d94" providerId="LiveId" clId="{1E8D713A-D82B-4018-844E-FF6439E2D0FB}" dt="2021-09-17T17:14:39.901" v="700" actId="165"/>
          <ac:grpSpMkLst>
            <pc:docMk/>
            <pc:sldMk cId="380902020" sldId="256"/>
            <ac:grpSpMk id="141" creationId="{F27D7C4B-C8F3-49DB-B9C5-B037AE720144}"/>
          </ac:grpSpMkLst>
        </pc:grpChg>
        <pc:grpChg chg="add del mod">
          <ac:chgData name="Lois Hoyer" userId="8c378a1a5b622d94" providerId="LiveId" clId="{1E8D713A-D82B-4018-844E-FF6439E2D0FB}" dt="2021-09-17T17:14:25.496" v="699" actId="165"/>
          <ac:grpSpMkLst>
            <pc:docMk/>
            <pc:sldMk cId="380902020" sldId="256"/>
            <ac:grpSpMk id="142" creationId="{4D86054B-E1A2-4EE6-81B6-A2A638738D6B}"/>
          </ac:grpSpMkLst>
        </pc:grpChg>
        <pc:graphicFrameChg chg="add mod modGraphic">
          <ac:chgData name="Lois Hoyer" userId="8c378a1a5b622d94" providerId="LiveId" clId="{1E8D713A-D82B-4018-844E-FF6439E2D0FB}" dt="2021-09-21T14:28:43.784" v="1223" actId="1076"/>
          <ac:graphicFrameMkLst>
            <pc:docMk/>
            <pc:sldMk cId="380902020" sldId="256"/>
            <ac:graphicFrameMk id="143" creationId="{3B355656-213C-4340-8006-19291BC08EE2}"/>
          </ac:graphicFrameMkLst>
        </pc:graphicFrameChg>
      </pc:sldChg>
      <pc:sldChg chg="addSp delSp modSp new mod">
        <pc:chgData name="Lois Hoyer" userId="8c378a1a5b622d94" providerId="LiveId" clId="{1E8D713A-D82B-4018-844E-FF6439E2D0FB}" dt="2021-09-21T16:17:38.929" v="1227" actId="20577"/>
        <pc:sldMkLst>
          <pc:docMk/>
          <pc:sldMk cId="3034391636" sldId="257"/>
        </pc:sldMkLst>
        <pc:spChg chg="del">
          <ac:chgData name="Lois Hoyer" userId="8c378a1a5b622d94" providerId="LiveId" clId="{1E8D713A-D82B-4018-844E-FF6439E2D0FB}" dt="2021-09-21T14:19:59.289" v="752" actId="478"/>
          <ac:spMkLst>
            <pc:docMk/>
            <pc:sldMk cId="3034391636" sldId="257"/>
            <ac:spMk id="2" creationId="{C5EED00F-597D-4780-9FE0-E765F548E1EC}"/>
          </ac:spMkLst>
        </pc:spChg>
        <pc:spChg chg="del">
          <ac:chgData name="Lois Hoyer" userId="8c378a1a5b622d94" providerId="LiveId" clId="{1E8D713A-D82B-4018-844E-FF6439E2D0FB}" dt="2021-09-21T14:20:00.743" v="753" actId="478"/>
          <ac:spMkLst>
            <pc:docMk/>
            <pc:sldMk cId="3034391636" sldId="257"/>
            <ac:spMk id="3" creationId="{CD89E4E8-9CB6-43FD-BE49-733347A4026C}"/>
          </ac:spMkLst>
        </pc:spChg>
        <pc:spChg chg="add del mod">
          <ac:chgData name="Lois Hoyer" userId="8c378a1a5b622d94" providerId="LiveId" clId="{1E8D713A-D82B-4018-844E-FF6439E2D0FB}" dt="2021-09-21T14:21:11.786" v="793" actId="478"/>
          <ac:spMkLst>
            <pc:docMk/>
            <pc:sldMk cId="3034391636" sldId="257"/>
            <ac:spMk id="4" creationId="{32DF8D78-A901-4F0A-AC0D-5F3FD32A218C}"/>
          </ac:spMkLst>
        </pc:spChg>
        <pc:spChg chg="add mod">
          <ac:chgData name="Lois Hoyer" userId="8c378a1a5b622d94" providerId="LiveId" clId="{1E8D713A-D82B-4018-844E-FF6439E2D0FB}" dt="2021-09-21T16:17:38.929" v="1227" actId="20577"/>
          <ac:spMkLst>
            <pc:docMk/>
            <pc:sldMk cId="3034391636" sldId="257"/>
            <ac:spMk id="5" creationId="{83241463-9083-4C78-A9E3-00397E18F34F}"/>
          </ac:spMkLst>
        </pc:spChg>
      </pc:sldChg>
    </pc:docChg>
  </pc:docChgLst>
  <pc:docChgLst>
    <pc:chgData name="Lois Hoyer" userId="8c378a1a5b622d94" providerId="LiveId" clId="{210CE177-ECB4-42C9-87C0-67AB1B8CA5DC}"/>
    <pc:docChg chg="modSld">
      <pc:chgData name="Lois Hoyer" userId="8c378a1a5b622d94" providerId="LiveId" clId="{210CE177-ECB4-42C9-87C0-67AB1B8CA5DC}" dt="2021-10-03T15:25:11.990" v="199" actId="20577"/>
      <pc:docMkLst>
        <pc:docMk/>
      </pc:docMkLst>
      <pc:sldChg chg="modSp mod">
        <pc:chgData name="Lois Hoyer" userId="8c378a1a5b622d94" providerId="LiveId" clId="{210CE177-ECB4-42C9-87C0-67AB1B8CA5DC}" dt="2021-10-03T15:25:11.990" v="199" actId="20577"/>
        <pc:sldMkLst>
          <pc:docMk/>
          <pc:sldMk cId="380902020" sldId="256"/>
        </pc:sldMkLst>
        <pc:spChg chg="mod">
          <ac:chgData name="Lois Hoyer" userId="8c378a1a5b622d94" providerId="LiveId" clId="{210CE177-ECB4-42C9-87C0-67AB1B8CA5DC}" dt="2021-10-03T14:57:36.340" v="74" actId="20577"/>
          <ac:spMkLst>
            <pc:docMk/>
            <pc:sldMk cId="380902020" sldId="256"/>
            <ac:spMk id="123" creationId="{77122AB3-B699-4E31-8495-4BBF6D32F44F}"/>
          </ac:spMkLst>
        </pc:spChg>
        <pc:spChg chg="mod">
          <ac:chgData name="Lois Hoyer" userId="8c378a1a5b622d94" providerId="LiveId" clId="{210CE177-ECB4-42C9-87C0-67AB1B8CA5DC}" dt="2021-09-28T14:31:21.617" v="72" actId="20577"/>
          <ac:spMkLst>
            <pc:docMk/>
            <pc:sldMk cId="380902020" sldId="256"/>
            <ac:spMk id="145" creationId="{56603B88-69D2-4969-A0F8-CF996CB13C03}"/>
          </ac:spMkLst>
        </pc:spChg>
        <pc:spChg chg="mod">
          <ac:chgData name="Lois Hoyer" userId="8c378a1a5b622d94" providerId="LiveId" clId="{210CE177-ECB4-42C9-87C0-67AB1B8CA5DC}" dt="2021-10-03T15:18:49.120" v="145" actId="20577"/>
          <ac:spMkLst>
            <pc:docMk/>
            <pc:sldMk cId="380902020" sldId="256"/>
            <ac:spMk id="147" creationId="{4B9B9B2E-2062-4ED9-B18B-636503BF946B}"/>
          </ac:spMkLst>
        </pc:spChg>
        <pc:spChg chg="mod">
          <ac:chgData name="Lois Hoyer" userId="8c378a1a5b622d94" providerId="LiveId" clId="{210CE177-ECB4-42C9-87C0-67AB1B8CA5DC}" dt="2021-10-03T15:25:11.990" v="199" actId="20577"/>
          <ac:spMkLst>
            <pc:docMk/>
            <pc:sldMk cId="380902020" sldId="256"/>
            <ac:spMk id="148" creationId="{F670EB90-21AF-49E4-BB75-76209CADBF14}"/>
          </ac:spMkLst>
        </pc:spChg>
        <pc:spChg chg="mod">
          <ac:chgData name="Lois Hoyer" userId="8c378a1a5b622d94" providerId="LiveId" clId="{210CE177-ECB4-42C9-87C0-67AB1B8CA5DC}" dt="2021-09-28T14:28:41.446" v="3" actId="1076"/>
          <ac:spMkLst>
            <pc:docMk/>
            <pc:sldMk cId="380902020" sldId="256"/>
            <ac:spMk id="150" creationId="{3AC7763E-212E-42C6-B790-68DA6D9E8370}"/>
          </ac:spMkLst>
        </pc:spChg>
      </pc:sldChg>
      <pc:sldChg chg="modSp mod">
        <pc:chgData name="Lois Hoyer" userId="8c378a1a5b622d94" providerId="LiveId" clId="{210CE177-ECB4-42C9-87C0-67AB1B8CA5DC}" dt="2021-10-03T15:11:34.179" v="102" actId="20577"/>
        <pc:sldMkLst>
          <pc:docMk/>
          <pc:sldMk cId="3034391636" sldId="257"/>
        </pc:sldMkLst>
        <pc:spChg chg="mod">
          <ac:chgData name="Lois Hoyer" userId="8c378a1a5b622d94" providerId="LiveId" clId="{210CE177-ECB4-42C9-87C0-67AB1B8CA5DC}" dt="2021-10-03T15:11:34.179" v="102" actId="20577"/>
          <ac:spMkLst>
            <pc:docMk/>
            <pc:sldMk cId="3034391636" sldId="257"/>
            <ac:spMk id="5" creationId="{83241463-9083-4C78-A9E3-00397E18F34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491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4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977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5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67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642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767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41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938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381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227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146D1-CFD3-44CA-B4CF-80C1703819D4}" type="datetimeFigureOut">
              <a:rPr lang="en-US" smtClean="0"/>
              <a:t>10/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B450A-E902-4F66-9E56-CE20D350A4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13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6" name="Group 135">
            <a:extLst>
              <a:ext uri="{FF2B5EF4-FFF2-40B4-BE49-F238E27FC236}">
                <a16:creationId xmlns:a16="http://schemas.microsoft.com/office/drawing/2014/main" id="{9F6DAB1B-76B4-4E48-B095-5A44A8251152}"/>
              </a:ext>
            </a:extLst>
          </p:cNvPr>
          <p:cNvGrpSpPr/>
          <p:nvPr/>
        </p:nvGrpSpPr>
        <p:grpSpPr>
          <a:xfrm>
            <a:off x="5773089" y="2118026"/>
            <a:ext cx="2558522" cy="1063463"/>
            <a:chOff x="5431359" y="2331808"/>
            <a:chExt cx="2558522" cy="1063463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8A08B8A-1DBA-4335-A4FE-17230DFE4924}"/>
                </a:ext>
              </a:extLst>
            </p:cNvPr>
            <p:cNvGrpSpPr/>
            <p:nvPr/>
          </p:nvGrpSpPr>
          <p:grpSpPr>
            <a:xfrm>
              <a:off x="7193169" y="2740429"/>
              <a:ext cx="796712" cy="246221"/>
              <a:chOff x="3651681" y="2836383"/>
              <a:chExt cx="796712" cy="246221"/>
            </a:xfrm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C53B7DEB-0242-4DA1-AD1A-18B89AB23B1B}"/>
                  </a:ext>
                </a:extLst>
              </p:cNvPr>
              <p:cNvSpPr/>
              <p:nvPr/>
            </p:nvSpPr>
            <p:spPr>
              <a:xfrm>
                <a:off x="3651681" y="2840621"/>
                <a:ext cx="237744" cy="23774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7A22548-54DF-40F4-84DC-95AB081A9103}"/>
                  </a:ext>
                </a:extLst>
              </p:cNvPr>
              <p:cNvSpPr txBox="1"/>
              <p:nvPr/>
            </p:nvSpPr>
            <p:spPr>
              <a:xfrm>
                <a:off x="3875800" y="2836383"/>
                <a:ext cx="572593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 aa</a:t>
                </a:r>
              </a:p>
            </p:txBody>
          </p:sp>
        </p:grp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8ABA59C4-8339-4A46-87AC-865B0CF151E3}"/>
                </a:ext>
              </a:extLst>
            </p:cNvPr>
            <p:cNvGrpSpPr/>
            <p:nvPr/>
          </p:nvGrpSpPr>
          <p:grpSpPr>
            <a:xfrm>
              <a:off x="5431359" y="2331808"/>
              <a:ext cx="1839540" cy="1063463"/>
              <a:chOff x="6762671" y="4657965"/>
              <a:chExt cx="1839540" cy="1063463"/>
            </a:xfrm>
          </p:grpSpPr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7E0F1560-C29E-4073-9F75-68ACF0D10CE8}"/>
                  </a:ext>
                </a:extLst>
              </p:cNvPr>
              <p:cNvSpPr/>
              <p:nvPr/>
            </p:nvSpPr>
            <p:spPr>
              <a:xfrm>
                <a:off x="6955966" y="4689487"/>
                <a:ext cx="152400" cy="1524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5" name="Rectangle 114">
                <a:extLst>
                  <a:ext uri="{FF2B5EF4-FFF2-40B4-BE49-F238E27FC236}">
                    <a16:creationId xmlns:a16="http://schemas.microsoft.com/office/drawing/2014/main" id="{A4120B7B-1062-48A4-92B0-A6B7DE0A752D}"/>
                  </a:ext>
                </a:extLst>
              </p:cNvPr>
              <p:cNvSpPr/>
              <p:nvPr/>
            </p:nvSpPr>
            <p:spPr>
              <a:xfrm>
                <a:off x="6955966" y="4901492"/>
                <a:ext cx="152400" cy="1524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84B325BC-23BA-42AC-A61B-F5BA8E08D919}"/>
                  </a:ext>
                </a:extLst>
              </p:cNvPr>
              <p:cNvSpPr/>
              <p:nvPr/>
            </p:nvSpPr>
            <p:spPr>
              <a:xfrm>
                <a:off x="6955966" y="5113497"/>
                <a:ext cx="152400" cy="152400"/>
              </a:xfrm>
              <a:prstGeom prst="rect">
                <a:avLst/>
              </a:prstGeom>
              <a:solidFill>
                <a:srgbClr val="38572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7" name="Rectangle 116">
                <a:extLst>
                  <a:ext uri="{FF2B5EF4-FFF2-40B4-BE49-F238E27FC236}">
                    <a16:creationId xmlns:a16="http://schemas.microsoft.com/office/drawing/2014/main" id="{AD3045DA-26B3-416D-B589-425D37751EEF}"/>
                  </a:ext>
                </a:extLst>
              </p:cNvPr>
              <p:cNvSpPr/>
              <p:nvPr/>
            </p:nvSpPr>
            <p:spPr>
              <a:xfrm>
                <a:off x="6762671" y="5112886"/>
                <a:ext cx="152400" cy="152400"/>
              </a:xfrm>
              <a:prstGeom prst="rect">
                <a:avLst/>
              </a:prstGeom>
              <a:solidFill>
                <a:srgbClr val="A9D18E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8" name="Rectangle 117">
                <a:extLst>
                  <a:ext uri="{FF2B5EF4-FFF2-40B4-BE49-F238E27FC236}">
                    <a16:creationId xmlns:a16="http://schemas.microsoft.com/office/drawing/2014/main" id="{45FED51F-C253-4509-BE45-D5C169B53156}"/>
                  </a:ext>
                </a:extLst>
              </p:cNvPr>
              <p:cNvSpPr/>
              <p:nvPr/>
            </p:nvSpPr>
            <p:spPr>
              <a:xfrm>
                <a:off x="6762671" y="5325502"/>
                <a:ext cx="152400" cy="152400"/>
              </a:xfrm>
              <a:prstGeom prst="rect">
                <a:avLst/>
              </a:prstGeom>
              <a:solidFill>
                <a:srgbClr val="0066CC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A64CD0E0-ECF7-4C99-B223-47ED965E18F2}"/>
                  </a:ext>
                </a:extLst>
              </p:cNvPr>
              <p:cNvSpPr/>
              <p:nvPr/>
            </p:nvSpPr>
            <p:spPr>
              <a:xfrm>
                <a:off x="6955966" y="5325502"/>
                <a:ext cx="152400" cy="152400"/>
              </a:xfrm>
              <a:prstGeom prst="rect">
                <a:avLst/>
              </a:prstGeom>
              <a:solidFill>
                <a:srgbClr val="0066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0" name="Rectangle 119">
                <a:extLst>
                  <a:ext uri="{FF2B5EF4-FFF2-40B4-BE49-F238E27FC236}">
                    <a16:creationId xmlns:a16="http://schemas.microsoft.com/office/drawing/2014/main" id="{BD5B035F-0678-4F40-91E5-D65C0342FA01}"/>
                  </a:ext>
                </a:extLst>
              </p:cNvPr>
              <p:cNvSpPr/>
              <p:nvPr/>
            </p:nvSpPr>
            <p:spPr>
              <a:xfrm>
                <a:off x="7149261" y="5321857"/>
                <a:ext cx="152400" cy="152400"/>
              </a:xfrm>
              <a:prstGeom prst="rect">
                <a:avLst/>
              </a:prstGeom>
              <a:solidFill>
                <a:srgbClr val="3333CC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4A7708C6-7334-4D20-AECE-8C59EAB423E8}"/>
                  </a:ext>
                </a:extLst>
              </p:cNvPr>
              <p:cNvSpPr/>
              <p:nvPr/>
            </p:nvSpPr>
            <p:spPr>
              <a:xfrm>
                <a:off x="6955966" y="5537506"/>
                <a:ext cx="152400" cy="152400"/>
              </a:xfrm>
              <a:prstGeom prst="rect">
                <a:avLst/>
              </a:prstGeom>
              <a:solidFill>
                <a:srgbClr val="7030A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5A631DE6-4F56-485D-BDA2-89B41F74FC87}"/>
                  </a:ext>
                </a:extLst>
              </p:cNvPr>
              <p:cNvSpPr txBox="1"/>
              <p:nvPr/>
            </p:nvSpPr>
            <p:spPr>
              <a:xfrm>
                <a:off x="7281015" y="4657965"/>
                <a:ext cx="1321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ecretory Signal Peptide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77122AB3-B699-4E31-8495-4BBF6D32F44F}"/>
                  </a:ext>
                </a:extLst>
              </p:cNvPr>
              <p:cNvSpPr txBox="1"/>
              <p:nvPr/>
            </p:nvSpPr>
            <p:spPr>
              <a:xfrm>
                <a:off x="7281015" y="4871144"/>
                <a:ext cx="614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T-Als + 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3D6BAD10-97E9-45DE-8BBA-B3937CB27DD6}"/>
                  </a:ext>
                </a:extLst>
              </p:cNvPr>
              <p:cNvSpPr txBox="1"/>
              <p:nvPr/>
            </p:nvSpPr>
            <p:spPr>
              <a:xfrm>
                <a:off x="7281015" y="5078128"/>
                <a:ext cx="9765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andem Repeats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9C6E7825-36E3-4C31-9FDF-7C6C07353111}"/>
                  </a:ext>
                </a:extLst>
              </p:cNvPr>
              <p:cNvSpPr txBox="1"/>
              <p:nvPr/>
            </p:nvSpPr>
            <p:spPr>
              <a:xfrm>
                <a:off x="7281015" y="5505984"/>
                <a:ext cx="97174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PI Addition Site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C76E54CF-1C0A-4456-BCF5-DB83573196F2}"/>
                  </a:ext>
                </a:extLst>
              </p:cNvPr>
              <p:cNvSpPr txBox="1"/>
              <p:nvPr/>
            </p:nvSpPr>
            <p:spPr>
              <a:xfrm>
                <a:off x="7281015" y="5278007"/>
                <a:ext cx="7665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e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  <p:sp>
            <p:nvSpPr>
              <p:cNvPr id="132" name="Rectangle 131">
                <a:extLst>
                  <a:ext uri="{FF2B5EF4-FFF2-40B4-BE49-F238E27FC236}">
                    <a16:creationId xmlns:a16="http://schemas.microsoft.com/office/drawing/2014/main" id="{E2D503D4-FFBC-4F82-A622-5DE3F7798A70}"/>
                  </a:ext>
                </a:extLst>
              </p:cNvPr>
              <p:cNvSpPr/>
              <p:nvPr/>
            </p:nvSpPr>
            <p:spPr>
              <a:xfrm>
                <a:off x="7149261" y="5112886"/>
                <a:ext cx="152400" cy="152400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</p:grpSp>
      </p:grpSp>
      <p:graphicFrame>
        <p:nvGraphicFramePr>
          <p:cNvPr id="143" name="Table 142">
            <a:extLst>
              <a:ext uri="{FF2B5EF4-FFF2-40B4-BE49-F238E27FC236}">
                <a16:creationId xmlns:a16="http://schemas.microsoft.com/office/drawing/2014/main" id="{3B355656-213C-4340-8006-19291BC08E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8547029"/>
              </p:ext>
            </p:extLst>
          </p:nvPr>
        </p:nvGraphicFramePr>
        <p:xfrm>
          <a:off x="2166427" y="5379884"/>
          <a:ext cx="4511675" cy="83820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02335">
                  <a:extLst>
                    <a:ext uri="{9D8B030D-6E8A-4147-A177-3AD203B41FA5}">
                      <a16:colId xmlns:a16="http://schemas.microsoft.com/office/drawing/2014/main" val="2131190332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509173655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1583704248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936704474"/>
                    </a:ext>
                  </a:extLst>
                </a:gridCol>
                <a:gridCol w="902335">
                  <a:extLst>
                    <a:ext uri="{9D8B030D-6E8A-4147-A177-3AD203B41FA5}">
                      <a16:colId xmlns:a16="http://schemas.microsoft.com/office/drawing/2014/main" val="295937817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sAls238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sAls278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SsAls4579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8281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SsAls2386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9365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SsAls2786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341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SsAls4579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2254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CaAls3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34973000"/>
                  </a:ext>
                </a:extLst>
              </a:tr>
            </a:tbl>
          </a:graphicData>
        </a:graphic>
      </p:graphicFrame>
      <p:sp>
        <p:nvSpPr>
          <p:cNvPr id="144" name="TextBox 143">
            <a:extLst>
              <a:ext uri="{FF2B5EF4-FFF2-40B4-BE49-F238E27FC236}">
                <a16:creationId xmlns:a16="http://schemas.microsoft.com/office/drawing/2014/main" id="{6AC2FB6D-977D-42BA-AF69-C5887A998588}"/>
              </a:ext>
            </a:extLst>
          </p:cNvPr>
          <p:cNvSpPr txBox="1"/>
          <p:nvPr/>
        </p:nvSpPr>
        <p:spPr>
          <a:xfrm>
            <a:off x="1799591" y="5139799"/>
            <a:ext cx="5245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ercent identity values for comparisons between NT-Als sequences in each protein</a:t>
            </a:r>
          </a:p>
        </p:txBody>
      </p:sp>
      <p:sp>
        <p:nvSpPr>
          <p:cNvPr id="145" name="Rectangle 3">
            <a:extLst>
              <a:ext uri="{FF2B5EF4-FFF2-40B4-BE49-F238E27FC236}">
                <a16:creationId xmlns:a16="http://schemas.microsoft.com/office/drawing/2014/main" id="{56603B88-69D2-4969-A0F8-CF996CB13C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3075" y="3491400"/>
            <a:ext cx="4684602" cy="107721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ensus tandem repeat sequence in each protein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sAls2386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6 aa)</a:t>
            </a:r>
            <a:r>
              <a: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</a:t>
            </a:r>
            <a:r>
              <a:rPr kumimoji="0" lang="en-US" altLang="en-US" sz="10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NPTTT_TSTWTGTET_STTVTDTQGGTDTVIV_V</a:t>
            </a:r>
            <a:endParaRPr kumimoji="0" lang="en-US" altLang="en-US" sz="1000" b="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sAls2786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6 aa)        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G_PT_TITSVWTGTDTTT_TVTDTEGGTDTVIVQV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 Consensus (36 aa)     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_</a:t>
            </a:r>
            <a:r>
              <a:rPr kumimoji="0" lang="en-US" altLang="en-US" sz="10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VTTT</a:t>
            </a: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  <a:r>
              <a:rPr kumimoji="0" lang="en-US" altLang="en-US" sz="10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WS_S___T_T_T__P__T__V___E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r Consensus (36 aa)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NPT_T_T_________T_T_______TD____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pCoCm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Consensus (36 aa)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PT_T_T__WTG____T_T_T__PG_TD_V_V__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F92614F8-4E71-4AF7-A765-238649C84897}"/>
              </a:ext>
            </a:extLst>
          </p:cNvPr>
          <p:cNvGrpSpPr/>
          <p:nvPr/>
        </p:nvGrpSpPr>
        <p:grpSpPr>
          <a:xfrm>
            <a:off x="751491" y="664942"/>
            <a:ext cx="7088270" cy="1648678"/>
            <a:chOff x="289689" y="1127014"/>
            <a:chExt cx="7088270" cy="1648678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647DDF4-759B-481A-ABF3-7AA8F7097C11}"/>
                </a:ext>
              </a:extLst>
            </p:cNvPr>
            <p:cNvSpPr txBox="1"/>
            <p:nvPr/>
          </p:nvSpPr>
          <p:spPr>
            <a:xfrm>
              <a:off x="289689" y="1127014"/>
              <a:ext cx="1068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sAls2386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2E83ED4-51E8-4843-9413-0A607B240438}"/>
                </a:ext>
              </a:extLst>
            </p:cNvPr>
            <p:cNvSpPr txBox="1"/>
            <p:nvPr/>
          </p:nvSpPr>
          <p:spPr>
            <a:xfrm>
              <a:off x="289689" y="1751401"/>
              <a:ext cx="1068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sAls2786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1CC8FBC-C940-4F8C-8B1D-269BFBEAFAB5}"/>
                </a:ext>
              </a:extLst>
            </p:cNvPr>
            <p:cNvSpPr txBox="1"/>
            <p:nvPr/>
          </p:nvSpPr>
          <p:spPr>
            <a:xfrm>
              <a:off x="289689" y="2331808"/>
              <a:ext cx="1068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sAls4579</a:t>
              </a:r>
            </a:p>
          </p:txBody>
        </p:sp>
        <p:grpSp>
          <p:nvGrpSpPr>
            <p:cNvPr id="133" name="Group 132">
              <a:extLst>
                <a:ext uri="{FF2B5EF4-FFF2-40B4-BE49-F238E27FC236}">
                  <a16:creationId xmlns:a16="http://schemas.microsoft.com/office/drawing/2014/main" id="{94263382-7985-4621-BE0B-1B6FA9ABC393}"/>
                </a:ext>
              </a:extLst>
            </p:cNvPr>
            <p:cNvGrpSpPr/>
            <p:nvPr/>
          </p:nvGrpSpPr>
          <p:grpSpPr>
            <a:xfrm>
              <a:off x="527413" y="1333695"/>
              <a:ext cx="4838738" cy="228600"/>
              <a:chOff x="453751" y="1464219"/>
              <a:chExt cx="4838738" cy="228600"/>
            </a:xfrm>
          </p:grpSpPr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64C3A0DE-2C91-4535-AF7A-394814E83416}"/>
                  </a:ext>
                </a:extLst>
              </p:cNvPr>
              <p:cNvSpPr/>
              <p:nvPr/>
            </p:nvSpPr>
            <p:spPr>
              <a:xfrm>
                <a:off x="490463" y="1464219"/>
                <a:ext cx="914400" cy="2286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2C30B5B3-7C20-4A72-AE5A-16CC182652BF}"/>
                  </a:ext>
                </a:extLst>
              </p:cNvPr>
              <p:cNvSpPr/>
              <p:nvPr/>
            </p:nvSpPr>
            <p:spPr>
              <a:xfrm>
                <a:off x="5237625" y="1464219"/>
                <a:ext cx="54864" cy="228600"/>
              </a:xfrm>
              <a:prstGeom prst="rect">
                <a:avLst/>
              </a:prstGeom>
              <a:solidFill>
                <a:srgbClr val="7030A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7030A0"/>
                  </a:solidFill>
                </a:endParaRP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1788274D-7DAA-4CB4-B7FC-0D3AC7589C34}"/>
                  </a:ext>
                </a:extLst>
              </p:cNvPr>
              <p:cNvSpPr/>
              <p:nvPr/>
            </p:nvSpPr>
            <p:spPr>
              <a:xfrm>
                <a:off x="453751" y="1464219"/>
                <a:ext cx="36576" cy="2286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4"/>
                  </a:solidFill>
                </a:endParaRPr>
              </a:p>
            </p:txBody>
          </p:sp>
          <p:sp>
            <p:nvSpPr>
              <p:cNvPr id="8" name="Rectangle 7">
                <a:extLst>
                  <a:ext uri="{FF2B5EF4-FFF2-40B4-BE49-F238E27FC236}">
                    <a16:creationId xmlns:a16="http://schemas.microsoft.com/office/drawing/2014/main" id="{3584E819-1072-44B5-AD29-2BC2E3E3F614}"/>
                  </a:ext>
                </a:extLst>
              </p:cNvPr>
              <p:cNvSpPr/>
              <p:nvPr/>
            </p:nvSpPr>
            <p:spPr>
              <a:xfrm>
                <a:off x="2391505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0EA8121A-2563-4FAB-9306-905C2FBAE103}"/>
                  </a:ext>
                </a:extLst>
              </p:cNvPr>
              <p:cNvSpPr/>
              <p:nvPr/>
            </p:nvSpPr>
            <p:spPr>
              <a:xfrm>
                <a:off x="4743579" y="1464219"/>
                <a:ext cx="502920" cy="228600"/>
              </a:xfrm>
              <a:prstGeom prst="rect">
                <a:avLst/>
              </a:prstGeom>
              <a:solidFill>
                <a:srgbClr val="0066CC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71991C7-55BE-4B38-8499-4BC83CF330C2}"/>
                  </a:ext>
                </a:extLst>
              </p:cNvPr>
              <p:cNvSpPr/>
              <p:nvPr/>
            </p:nvSpPr>
            <p:spPr>
              <a:xfrm>
                <a:off x="1403801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7EC84E6-98DA-45C6-8227-41F49A2CD02A}"/>
                  </a:ext>
                </a:extLst>
              </p:cNvPr>
              <p:cNvSpPr/>
              <p:nvPr/>
            </p:nvSpPr>
            <p:spPr>
              <a:xfrm>
                <a:off x="1494833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DFD0AC64-0912-458A-B668-81CE91F1BF25}"/>
                  </a:ext>
                </a:extLst>
              </p:cNvPr>
              <p:cNvSpPr/>
              <p:nvPr/>
            </p:nvSpPr>
            <p:spPr>
              <a:xfrm>
                <a:off x="1585865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14076AB1-52D6-41EC-ACB9-9146159F994F}"/>
                  </a:ext>
                </a:extLst>
              </p:cNvPr>
              <p:cNvSpPr/>
              <p:nvPr/>
            </p:nvSpPr>
            <p:spPr>
              <a:xfrm>
                <a:off x="1670073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26159DAA-3378-4CFD-B48B-4085884F2CA5}"/>
                  </a:ext>
                </a:extLst>
              </p:cNvPr>
              <p:cNvSpPr/>
              <p:nvPr/>
            </p:nvSpPr>
            <p:spPr>
              <a:xfrm>
                <a:off x="1761105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8B6CEA89-DEA2-4B7D-852D-630D11CF0599}"/>
                  </a:ext>
                </a:extLst>
              </p:cNvPr>
              <p:cNvSpPr/>
              <p:nvPr/>
            </p:nvSpPr>
            <p:spPr>
              <a:xfrm>
                <a:off x="1852137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2B03AF00-5801-4B5C-9D1A-9B510178875B}"/>
                  </a:ext>
                </a:extLst>
              </p:cNvPr>
              <p:cNvSpPr/>
              <p:nvPr/>
            </p:nvSpPr>
            <p:spPr>
              <a:xfrm>
                <a:off x="1936345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8ED943C0-4F00-4CE1-8CE0-E8D84A631131}"/>
                  </a:ext>
                </a:extLst>
              </p:cNvPr>
              <p:cNvSpPr/>
              <p:nvPr/>
            </p:nvSpPr>
            <p:spPr>
              <a:xfrm>
                <a:off x="2027377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B6234098-4491-4151-8F6D-6566CCD8E1EF}"/>
                  </a:ext>
                </a:extLst>
              </p:cNvPr>
              <p:cNvSpPr/>
              <p:nvPr/>
            </p:nvSpPr>
            <p:spPr>
              <a:xfrm>
                <a:off x="2118409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CF4C54DE-4B3F-4AC3-AB9C-C14045395109}"/>
                  </a:ext>
                </a:extLst>
              </p:cNvPr>
              <p:cNvSpPr/>
              <p:nvPr/>
            </p:nvSpPr>
            <p:spPr>
              <a:xfrm>
                <a:off x="2209441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8AB1D928-8435-4347-AA6F-5EAD0778F64F}"/>
                  </a:ext>
                </a:extLst>
              </p:cNvPr>
              <p:cNvSpPr/>
              <p:nvPr/>
            </p:nvSpPr>
            <p:spPr>
              <a:xfrm>
                <a:off x="2300473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AE88B02D-1F58-4D12-9B2F-104DE09B04E1}"/>
                  </a:ext>
                </a:extLst>
              </p:cNvPr>
              <p:cNvSpPr/>
              <p:nvPr/>
            </p:nvSpPr>
            <p:spPr>
              <a:xfrm>
                <a:off x="2591857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2C365E4A-95A8-458B-A2ED-9C4B6A172947}"/>
                  </a:ext>
                </a:extLst>
              </p:cNvPr>
              <p:cNvSpPr/>
              <p:nvPr/>
            </p:nvSpPr>
            <p:spPr>
              <a:xfrm>
                <a:off x="2682889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674B89E5-5CA4-44B1-925B-516FC21D429F}"/>
                  </a:ext>
                </a:extLst>
              </p:cNvPr>
              <p:cNvSpPr/>
              <p:nvPr/>
            </p:nvSpPr>
            <p:spPr>
              <a:xfrm>
                <a:off x="2767097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DCD11C46-4AD5-4580-B4DA-978CCC459D5A}"/>
                  </a:ext>
                </a:extLst>
              </p:cNvPr>
              <p:cNvSpPr/>
              <p:nvPr/>
            </p:nvSpPr>
            <p:spPr>
              <a:xfrm>
                <a:off x="2858129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2795E41-B6F1-4E3F-B02D-BA18EC34DE78}"/>
                  </a:ext>
                </a:extLst>
              </p:cNvPr>
              <p:cNvSpPr/>
              <p:nvPr/>
            </p:nvSpPr>
            <p:spPr>
              <a:xfrm>
                <a:off x="2949161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35E50ACA-C8DC-408A-9A4F-E42555A36035}"/>
                  </a:ext>
                </a:extLst>
              </p:cNvPr>
              <p:cNvSpPr/>
              <p:nvPr/>
            </p:nvSpPr>
            <p:spPr>
              <a:xfrm>
                <a:off x="3033369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F0C53207-1C06-4CAF-9368-D198DD1B2D26}"/>
                  </a:ext>
                </a:extLst>
              </p:cNvPr>
              <p:cNvSpPr/>
              <p:nvPr/>
            </p:nvSpPr>
            <p:spPr>
              <a:xfrm>
                <a:off x="2491681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2A64D5B1-0F40-4700-BB87-3277C3CC7364}"/>
                  </a:ext>
                </a:extLst>
              </p:cNvPr>
              <p:cNvSpPr/>
              <p:nvPr/>
            </p:nvSpPr>
            <p:spPr>
              <a:xfrm>
                <a:off x="4261448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545F580-95A5-4DA5-9676-9FEBAE0444BC}"/>
                  </a:ext>
                </a:extLst>
              </p:cNvPr>
              <p:cNvSpPr/>
              <p:nvPr/>
            </p:nvSpPr>
            <p:spPr>
              <a:xfrm>
                <a:off x="4353673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E927BF54-6C30-460E-A4F0-208CDB67FE9E}"/>
                  </a:ext>
                </a:extLst>
              </p:cNvPr>
              <p:cNvSpPr/>
              <p:nvPr/>
            </p:nvSpPr>
            <p:spPr>
              <a:xfrm>
                <a:off x="4447025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0A015689-3468-4E81-A48D-555E51C647F9}"/>
                  </a:ext>
                </a:extLst>
              </p:cNvPr>
              <p:cNvSpPr/>
              <p:nvPr/>
            </p:nvSpPr>
            <p:spPr>
              <a:xfrm>
                <a:off x="4547201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5581D6BD-69D7-46ED-9B95-3B84806E3C35}"/>
                  </a:ext>
                </a:extLst>
              </p:cNvPr>
              <p:cNvSpPr/>
              <p:nvPr/>
            </p:nvSpPr>
            <p:spPr>
              <a:xfrm>
                <a:off x="4647367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12D30921-7CB7-42A4-9256-404970B5B152}"/>
                  </a:ext>
                </a:extLst>
              </p:cNvPr>
              <p:cNvSpPr/>
              <p:nvPr/>
            </p:nvSpPr>
            <p:spPr>
              <a:xfrm>
                <a:off x="3124401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5C807E02-4C81-4914-8CFA-988742247FA7}"/>
                  </a:ext>
                </a:extLst>
              </p:cNvPr>
              <p:cNvSpPr/>
              <p:nvPr/>
            </p:nvSpPr>
            <p:spPr>
              <a:xfrm>
                <a:off x="3308785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B1B5C760-FD2D-4D15-ACFA-2025FB0FE91E}"/>
                  </a:ext>
                </a:extLst>
              </p:cNvPr>
              <p:cNvSpPr/>
              <p:nvPr/>
            </p:nvSpPr>
            <p:spPr>
              <a:xfrm>
                <a:off x="3584201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4A25A915-E48D-4428-AD4D-9972145DC0DE}"/>
                  </a:ext>
                </a:extLst>
              </p:cNvPr>
              <p:cNvSpPr/>
              <p:nvPr/>
            </p:nvSpPr>
            <p:spPr>
              <a:xfrm>
                <a:off x="3684377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57B92455-0D78-43CE-8803-F04E921A4F8A}"/>
                  </a:ext>
                </a:extLst>
              </p:cNvPr>
              <p:cNvSpPr/>
              <p:nvPr/>
            </p:nvSpPr>
            <p:spPr>
              <a:xfrm>
                <a:off x="3959793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ED77AD38-6AF4-4219-A01E-E9B07CC1DA30}"/>
                  </a:ext>
                </a:extLst>
              </p:cNvPr>
              <p:cNvSpPr/>
              <p:nvPr/>
            </p:nvSpPr>
            <p:spPr>
              <a:xfrm>
                <a:off x="4059969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4AFC4CA9-AD5F-472A-971A-1CA4B23C367E}"/>
                  </a:ext>
                </a:extLst>
              </p:cNvPr>
              <p:cNvSpPr/>
              <p:nvPr/>
            </p:nvSpPr>
            <p:spPr>
              <a:xfrm>
                <a:off x="4161272" y="1464219"/>
                <a:ext cx="91440" cy="228600"/>
              </a:xfrm>
              <a:prstGeom prst="rect">
                <a:avLst/>
              </a:prstGeom>
              <a:solidFill>
                <a:schemeClr val="accent6">
                  <a:lumMod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C7E7A64E-6CC6-47A2-8B58-EEDE52FE46A7}"/>
                  </a:ext>
                </a:extLst>
              </p:cNvPr>
              <p:cNvSpPr/>
              <p:nvPr/>
            </p:nvSpPr>
            <p:spPr>
              <a:xfrm>
                <a:off x="3785680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5B806C55-6CAB-4C17-8C05-9B7D8EE20487}"/>
                  </a:ext>
                </a:extLst>
              </p:cNvPr>
              <p:cNvSpPr/>
              <p:nvPr/>
            </p:nvSpPr>
            <p:spPr>
              <a:xfrm>
                <a:off x="3868761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Rectangle 43">
                <a:extLst>
                  <a:ext uri="{FF2B5EF4-FFF2-40B4-BE49-F238E27FC236}">
                    <a16:creationId xmlns:a16="http://schemas.microsoft.com/office/drawing/2014/main" id="{E1F38D94-51CF-4B8F-82CF-B18F4A0FEA9A}"/>
                  </a:ext>
                </a:extLst>
              </p:cNvPr>
              <p:cNvSpPr/>
              <p:nvPr/>
            </p:nvSpPr>
            <p:spPr>
              <a:xfrm>
                <a:off x="3217753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90D3B040-D604-43FD-9575-738BF018FB6E}"/>
                  </a:ext>
                </a:extLst>
              </p:cNvPr>
              <p:cNvSpPr/>
              <p:nvPr/>
            </p:nvSpPr>
            <p:spPr>
              <a:xfrm>
                <a:off x="3402137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0E18AE9F-10C1-4E5E-A44D-72DE10AAB00D}"/>
                  </a:ext>
                </a:extLst>
              </p:cNvPr>
              <p:cNvSpPr/>
              <p:nvPr/>
            </p:nvSpPr>
            <p:spPr>
              <a:xfrm>
                <a:off x="3493169" y="1464219"/>
                <a:ext cx="82296" cy="228600"/>
              </a:xfrm>
              <a:prstGeom prst="rect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4D63C2D-B052-4529-AAB5-F953D6A141A7}"/>
                </a:ext>
              </a:extLst>
            </p:cNvPr>
            <p:cNvGrpSpPr/>
            <p:nvPr/>
          </p:nvGrpSpPr>
          <p:grpSpPr>
            <a:xfrm>
              <a:off x="527413" y="1956551"/>
              <a:ext cx="6850546" cy="228600"/>
              <a:chOff x="527413" y="1956551"/>
              <a:chExt cx="6850546" cy="228600"/>
            </a:xfrm>
          </p:grpSpPr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816331E3-6B3E-4988-B5ED-58D0F087754D}"/>
                  </a:ext>
                </a:extLst>
              </p:cNvPr>
              <p:cNvSpPr/>
              <p:nvPr/>
            </p:nvSpPr>
            <p:spPr>
              <a:xfrm>
                <a:off x="148187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F8F2B976-4AE0-4D48-B594-8DF1973FFB2D}"/>
                  </a:ext>
                </a:extLst>
              </p:cNvPr>
              <p:cNvSpPr/>
              <p:nvPr/>
            </p:nvSpPr>
            <p:spPr>
              <a:xfrm>
                <a:off x="157380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0BAED963-EA20-4AA5-BB2C-7D6D04A30C4F}"/>
                  </a:ext>
                </a:extLst>
              </p:cNvPr>
              <p:cNvSpPr/>
              <p:nvPr/>
            </p:nvSpPr>
            <p:spPr>
              <a:xfrm>
                <a:off x="165891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851B09DB-0EE1-4757-B28A-266226E3369F}"/>
                  </a:ext>
                </a:extLst>
              </p:cNvPr>
              <p:cNvSpPr/>
              <p:nvPr/>
            </p:nvSpPr>
            <p:spPr>
              <a:xfrm>
                <a:off x="175085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" name="Rectangle 52">
                <a:extLst>
                  <a:ext uri="{FF2B5EF4-FFF2-40B4-BE49-F238E27FC236}">
                    <a16:creationId xmlns:a16="http://schemas.microsoft.com/office/drawing/2014/main" id="{F619A7EB-4154-4B8D-9DBD-65AA491B3089}"/>
                  </a:ext>
                </a:extLst>
              </p:cNvPr>
              <p:cNvSpPr/>
              <p:nvPr/>
            </p:nvSpPr>
            <p:spPr>
              <a:xfrm>
                <a:off x="183595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" name="Rectangle 53">
                <a:extLst>
                  <a:ext uri="{FF2B5EF4-FFF2-40B4-BE49-F238E27FC236}">
                    <a16:creationId xmlns:a16="http://schemas.microsoft.com/office/drawing/2014/main" id="{C2F67B9D-1FD1-4AF6-9F41-51BDA8E02D83}"/>
                  </a:ext>
                </a:extLst>
              </p:cNvPr>
              <p:cNvSpPr/>
              <p:nvPr/>
            </p:nvSpPr>
            <p:spPr>
              <a:xfrm>
                <a:off x="192789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" name="Rectangle 54">
                <a:extLst>
                  <a:ext uri="{FF2B5EF4-FFF2-40B4-BE49-F238E27FC236}">
                    <a16:creationId xmlns:a16="http://schemas.microsoft.com/office/drawing/2014/main" id="{84B27E5B-4DB8-4C6D-8824-BF1DE52CD93C}"/>
                  </a:ext>
                </a:extLst>
              </p:cNvPr>
              <p:cNvSpPr/>
              <p:nvPr/>
            </p:nvSpPr>
            <p:spPr>
              <a:xfrm>
                <a:off x="201300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20511B62-BD14-4229-8F45-9C9379B13F6B}"/>
                  </a:ext>
                </a:extLst>
              </p:cNvPr>
              <p:cNvSpPr/>
              <p:nvPr/>
            </p:nvSpPr>
            <p:spPr>
              <a:xfrm>
                <a:off x="210493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" name="Rectangle 56">
                <a:extLst>
                  <a:ext uri="{FF2B5EF4-FFF2-40B4-BE49-F238E27FC236}">
                    <a16:creationId xmlns:a16="http://schemas.microsoft.com/office/drawing/2014/main" id="{96C20C2A-8C3A-49D6-8B27-28B5F54E57F0}"/>
                  </a:ext>
                </a:extLst>
              </p:cNvPr>
              <p:cNvSpPr/>
              <p:nvPr/>
            </p:nvSpPr>
            <p:spPr>
              <a:xfrm>
                <a:off x="219004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60D80F0D-1204-47FF-8213-3CC400B614CE}"/>
                  </a:ext>
                </a:extLst>
              </p:cNvPr>
              <p:cNvSpPr/>
              <p:nvPr/>
            </p:nvSpPr>
            <p:spPr>
              <a:xfrm>
                <a:off x="2281976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Rectangle 58">
                <a:extLst>
                  <a:ext uri="{FF2B5EF4-FFF2-40B4-BE49-F238E27FC236}">
                    <a16:creationId xmlns:a16="http://schemas.microsoft.com/office/drawing/2014/main" id="{71C7E459-A645-4234-9D9C-88AF15417D0C}"/>
                  </a:ext>
                </a:extLst>
              </p:cNvPr>
              <p:cNvSpPr/>
              <p:nvPr/>
            </p:nvSpPr>
            <p:spPr>
              <a:xfrm>
                <a:off x="236708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26B8D77D-6694-49DE-B321-C04CB6BFAEFC}"/>
                  </a:ext>
                </a:extLst>
              </p:cNvPr>
              <p:cNvSpPr/>
              <p:nvPr/>
            </p:nvSpPr>
            <p:spPr>
              <a:xfrm>
                <a:off x="245901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Rectangle 60">
                <a:extLst>
                  <a:ext uri="{FF2B5EF4-FFF2-40B4-BE49-F238E27FC236}">
                    <a16:creationId xmlns:a16="http://schemas.microsoft.com/office/drawing/2014/main" id="{8D648E33-59A1-4520-B546-50363BC0D7FE}"/>
                  </a:ext>
                </a:extLst>
              </p:cNvPr>
              <p:cNvSpPr/>
              <p:nvPr/>
            </p:nvSpPr>
            <p:spPr>
              <a:xfrm>
                <a:off x="254412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96DEB5E0-377A-4404-B038-519D9CDE22B3}"/>
                  </a:ext>
                </a:extLst>
              </p:cNvPr>
              <p:cNvSpPr/>
              <p:nvPr/>
            </p:nvSpPr>
            <p:spPr>
              <a:xfrm>
                <a:off x="263811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" name="Rectangle 62">
                <a:extLst>
                  <a:ext uri="{FF2B5EF4-FFF2-40B4-BE49-F238E27FC236}">
                    <a16:creationId xmlns:a16="http://schemas.microsoft.com/office/drawing/2014/main" id="{0640907E-9269-4BF2-80F6-BB82EBF37CB1}"/>
                  </a:ext>
                </a:extLst>
              </p:cNvPr>
              <p:cNvSpPr/>
              <p:nvPr/>
            </p:nvSpPr>
            <p:spPr>
              <a:xfrm>
                <a:off x="280627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Rectangle 63">
                <a:extLst>
                  <a:ext uri="{FF2B5EF4-FFF2-40B4-BE49-F238E27FC236}">
                    <a16:creationId xmlns:a16="http://schemas.microsoft.com/office/drawing/2014/main" id="{3302CAD9-271F-42EB-A600-7E6ED2CA0B47}"/>
                  </a:ext>
                </a:extLst>
              </p:cNvPr>
              <p:cNvSpPr/>
              <p:nvPr/>
            </p:nvSpPr>
            <p:spPr>
              <a:xfrm>
                <a:off x="272116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756B6C94-39A7-4DF0-BD89-C2B7485C3688}"/>
                  </a:ext>
                </a:extLst>
              </p:cNvPr>
              <p:cNvSpPr/>
              <p:nvPr/>
            </p:nvSpPr>
            <p:spPr>
              <a:xfrm>
                <a:off x="289821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Rectangle 65">
                <a:extLst>
                  <a:ext uri="{FF2B5EF4-FFF2-40B4-BE49-F238E27FC236}">
                    <a16:creationId xmlns:a16="http://schemas.microsoft.com/office/drawing/2014/main" id="{434FB8AB-15AC-4792-94C1-B518E9EB2B97}"/>
                  </a:ext>
                </a:extLst>
              </p:cNvPr>
              <p:cNvSpPr/>
              <p:nvPr/>
            </p:nvSpPr>
            <p:spPr>
              <a:xfrm>
                <a:off x="298332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Rectangle 66">
                <a:extLst>
                  <a:ext uri="{FF2B5EF4-FFF2-40B4-BE49-F238E27FC236}">
                    <a16:creationId xmlns:a16="http://schemas.microsoft.com/office/drawing/2014/main" id="{6579CA24-4D39-4D13-9052-1069B15BC590}"/>
                  </a:ext>
                </a:extLst>
              </p:cNvPr>
              <p:cNvSpPr/>
              <p:nvPr/>
            </p:nvSpPr>
            <p:spPr>
              <a:xfrm>
                <a:off x="307525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41F16969-6017-49A4-8D9F-AE691C6F0E66}"/>
                  </a:ext>
                </a:extLst>
              </p:cNvPr>
              <p:cNvSpPr/>
              <p:nvPr/>
            </p:nvSpPr>
            <p:spPr>
              <a:xfrm>
                <a:off x="316036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9" name="Rectangle 68">
                <a:extLst>
                  <a:ext uri="{FF2B5EF4-FFF2-40B4-BE49-F238E27FC236}">
                    <a16:creationId xmlns:a16="http://schemas.microsoft.com/office/drawing/2014/main" id="{F687A96F-8DBB-4F0C-8A75-7210BECB58C0}"/>
                  </a:ext>
                </a:extLst>
              </p:cNvPr>
              <p:cNvSpPr/>
              <p:nvPr/>
            </p:nvSpPr>
            <p:spPr>
              <a:xfrm>
                <a:off x="325229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Rectangle 69">
                <a:extLst>
                  <a:ext uri="{FF2B5EF4-FFF2-40B4-BE49-F238E27FC236}">
                    <a16:creationId xmlns:a16="http://schemas.microsoft.com/office/drawing/2014/main" id="{7C73FD2F-92A5-43E6-84E5-D555DDC8BDA2}"/>
                  </a:ext>
                </a:extLst>
              </p:cNvPr>
              <p:cNvSpPr/>
              <p:nvPr/>
            </p:nvSpPr>
            <p:spPr>
              <a:xfrm>
                <a:off x="333740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A0BA3036-A571-4CC6-8C1A-A6D46C347849}"/>
                  </a:ext>
                </a:extLst>
              </p:cNvPr>
              <p:cNvSpPr/>
              <p:nvPr/>
            </p:nvSpPr>
            <p:spPr>
              <a:xfrm>
                <a:off x="342933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2" name="Rectangle 71">
                <a:extLst>
                  <a:ext uri="{FF2B5EF4-FFF2-40B4-BE49-F238E27FC236}">
                    <a16:creationId xmlns:a16="http://schemas.microsoft.com/office/drawing/2014/main" id="{25D4EAB3-4275-4CD7-8436-5847D853BF0E}"/>
                  </a:ext>
                </a:extLst>
              </p:cNvPr>
              <p:cNvSpPr/>
              <p:nvPr/>
            </p:nvSpPr>
            <p:spPr>
              <a:xfrm>
                <a:off x="3514446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E8B80CFE-6ADB-4B28-A55F-E206D28CFE6D}"/>
                  </a:ext>
                </a:extLst>
              </p:cNvPr>
              <p:cNvSpPr/>
              <p:nvPr/>
            </p:nvSpPr>
            <p:spPr>
              <a:xfrm>
                <a:off x="360637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E8F6A316-E6F2-4B0D-B30C-6370938FA7F2}"/>
                  </a:ext>
                </a:extLst>
              </p:cNvPr>
              <p:cNvSpPr/>
              <p:nvPr/>
            </p:nvSpPr>
            <p:spPr>
              <a:xfrm>
                <a:off x="369148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Rectangle 74">
                <a:extLst>
                  <a:ext uri="{FF2B5EF4-FFF2-40B4-BE49-F238E27FC236}">
                    <a16:creationId xmlns:a16="http://schemas.microsoft.com/office/drawing/2014/main" id="{A05CC0FD-DDE9-463C-868E-DCE16D963B6B}"/>
                  </a:ext>
                </a:extLst>
              </p:cNvPr>
              <p:cNvSpPr/>
              <p:nvPr/>
            </p:nvSpPr>
            <p:spPr>
              <a:xfrm>
                <a:off x="378342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260966ED-EA91-4993-AD3F-149069F4EBAA}"/>
                  </a:ext>
                </a:extLst>
              </p:cNvPr>
              <p:cNvSpPr/>
              <p:nvPr/>
            </p:nvSpPr>
            <p:spPr>
              <a:xfrm>
                <a:off x="386853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D928C57D-C42A-41A2-BF98-071C64A7286E}"/>
                  </a:ext>
                </a:extLst>
              </p:cNvPr>
              <p:cNvSpPr/>
              <p:nvPr/>
            </p:nvSpPr>
            <p:spPr>
              <a:xfrm>
                <a:off x="396046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Rectangle 77">
                <a:extLst>
                  <a:ext uri="{FF2B5EF4-FFF2-40B4-BE49-F238E27FC236}">
                    <a16:creationId xmlns:a16="http://schemas.microsoft.com/office/drawing/2014/main" id="{6933330D-4E50-4A3C-8E7A-233FB407868E}"/>
                  </a:ext>
                </a:extLst>
              </p:cNvPr>
              <p:cNvSpPr/>
              <p:nvPr/>
            </p:nvSpPr>
            <p:spPr>
              <a:xfrm>
                <a:off x="404557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" name="Rectangle 78">
                <a:extLst>
                  <a:ext uri="{FF2B5EF4-FFF2-40B4-BE49-F238E27FC236}">
                    <a16:creationId xmlns:a16="http://schemas.microsoft.com/office/drawing/2014/main" id="{0E3D681E-AE3C-4251-ABC7-4511E4A2620D}"/>
                  </a:ext>
                </a:extLst>
              </p:cNvPr>
              <p:cNvSpPr/>
              <p:nvPr/>
            </p:nvSpPr>
            <p:spPr>
              <a:xfrm>
                <a:off x="413750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Rectangle 79">
                <a:extLst>
                  <a:ext uri="{FF2B5EF4-FFF2-40B4-BE49-F238E27FC236}">
                    <a16:creationId xmlns:a16="http://schemas.microsoft.com/office/drawing/2014/main" id="{2EED958C-125A-44D0-A8F6-F7A63AE0D8E3}"/>
                  </a:ext>
                </a:extLst>
              </p:cNvPr>
              <p:cNvSpPr/>
              <p:nvPr/>
            </p:nvSpPr>
            <p:spPr>
              <a:xfrm>
                <a:off x="422943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DE1AB3D8-0DC3-48C4-9A97-392F16653661}"/>
                  </a:ext>
                </a:extLst>
              </p:cNvPr>
              <p:cNvSpPr/>
              <p:nvPr/>
            </p:nvSpPr>
            <p:spPr>
              <a:xfrm>
                <a:off x="431454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9B167F42-ADE6-433E-9023-B58B4F15AB46}"/>
                  </a:ext>
                </a:extLst>
              </p:cNvPr>
              <p:cNvSpPr/>
              <p:nvPr/>
            </p:nvSpPr>
            <p:spPr>
              <a:xfrm>
                <a:off x="440648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01B73892-CE4B-491C-8703-971A718DFB4F}"/>
                  </a:ext>
                </a:extLst>
              </p:cNvPr>
              <p:cNvSpPr/>
              <p:nvPr/>
            </p:nvSpPr>
            <p:spPr>
              <a:xfrm>
                <a:off x="449158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142C2008-48C7-4489-831D-D57D1A81E0CA}"/>
                  </a:ext>
                </a:extLst>
              </p:cNvPr>
              <p:cNvSpPr/>
              <p:nvPr/>
            </p:nvSpPr>
            <p:spPr>
              <a:xfrm>
                <a:off x="458352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D987FC38-AE6F-4ED7-A814-4FB1FDC23BC9}"/>
                  </a:ext>
                </a:extLst>
              </p:cNvPr>
              <p:cNvSpPr/>
              <p:nvPr/>
            </p:nvSpPr>
            <p:spPr>
              <a:xfrm>
                <a:off x="466863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7C10356F-A067-438C-871A-5A69FA251C75}"/>
                  </a:ext>
                </a:extLst>
              </p:cNvPr>
              <p:cNvSpPr/>
              <p:nvPr/>
            </p:nvSpPr>
            <p:spPr>
              <a:xfrm>
                <a:off x="476056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A82104CA-CA6F-4644-BEE3-B9D187CCE7DD}"/>
                  </a:ext>
                </a:extLst>
              </p:cNvPr>
              <p:cNvSpPr/>
              <p:nvPr/>
            </p:nvSpPr>
            <p:spPr>
              <a:xfrm>
                <a:off x="484567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8" name="Rectangle 87">
                <a:extLst>
                  <a:ext uri="{FF2B5EF4-FFF2-40B4-BE49-F238E27FC236}">
                    <a16:creationId xmlns:a16="http://schemas.microsoft.com/office/drawing/2014/main" id="{41AA6EFC-E493-4860-8FE6-504B0853E6F9}"/>
                  </a:ext>
                </a:extLst>
              </p:cNvPr>
              <p:cNvSpPr/>
              <p:nvPr/>
            </p:nvSpPr>
            <p:spPr>
              <a:xfrm>
                <a:off x="4937606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9" name="Rectangle 88">
                <a:extLst>
                  <a:ext uri="{FF2B5EF4-FFF2-40B4-BE49-F238E27FC236}">
                    <a16:creationId xmlns:a16="http://schemas.microsoft.com/office/drawing/2014/main" id="{C65A2AD6-32E1-4299-9C94-D1C21D3F3177}"/>
                  </a:ext>
                </a:extLst>
              </p:cNvPr>
              <p:cNvSpPr/>
              <p:nvPr/>
            </p:nvSpPr>
            <p:spPr>
              <a:xfrm>
                <a:off x="502271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1D416637-0704-4752-8F6C-9F11093F5B1F}"/>
                  </a:ext>
                </a:extLst>
              </p:cNvPr>
              <p:cNvSpPr/>
              <p:nvPr/>
            </p:nvSpPr>
            <p:spPr>
              <a:xfrm>
                <a:off x="511464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6C305552-993E-4B1C-BE20-7B8FCE9BC2CD}"/>
                  </a:ext>
                </a:extLst>
              </p:cNvPr>
              <p:cNvSpPr/>
              <p:nvPr/>
            </p:nvSpPr>
            <p:spPr>
              <a:xfrm>
                <a:off x="519975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Rectangle 91">
                <a:extLst>
                  <a:ext uri="{FF2B5EF4-FFF2-40B4-BE49-F238E27FC236}">
                    <a16:creationId xmlns:a16="http://schemas.microsoft.com/office/drawing/2014/main" id="{0A97F099-E052-4A52-8D14-946C5D91E1F6}"/>
                  </a:ext>
                </a:extLst>
              </p:cNvPr>
              <p:cNvSpPr/>
              <p:nvPr/>
            </p:nvSpPr>
            <p:spPr>
              <a:xfrm>
                <a:off x="529169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7EE6519B-8DDE-4E16-8C85-0AD7D6A4C8D0}"/>
                  </a:ext>
                </a:extLst>
              </p:cNvPr>
              <p:cNvSpPr/>
              <p:nvPr/>
            </p:nvSpPr>
            <p:spPr>
              <a:xfrm>
                <a:off x="537679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E79F9B98-771F-40CA-BF41-9A788046639F}"/>
                  </a:ext>
                </a:extLst>
              </p:cNvPr>
              <p:cNvSpPr/>
              <p:nvPr/>
            </p:nvSpPr>
            <p:spPr>
              <a:xfrm>
                <a:off x="555384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5" name="Rectangle 94">
                <a:extLst>
                  <a:ext uri="{FF2B5EF4-FFF2-40B4-BE49-F238E27FC236}">
                    <a16:creationId xmlns:a16="http://schemas.microsoft.com/office/drawing/2014/main" id="{4E298672-0C5F-43C7-B012-9813D3B69742}"/>
                  </a:ext>
                </a:extLst>
              </p:cNvPr>
              <p:cNvSpPr/>
              <p:nvPr/>
            </p:nvSpPr>
            <p:spPr>
              <a:xfrm>
                <a:off x="573088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6" name="Rectangle 95">
                <a:extLst>
                  <a:ext uri="{FF2B5EF4-FFF2-40B4-BE49-F238E27FC236}">
                    <a16:creationId xmlns:a16="http://schemas.microsoft.com/office/drawing/2014/main" id="{9DEE6D81-D2C4-4171-B9D2-260852A4F560}"/>
                  </a:ext>
                </a:extLst>
              </p:cNvPr>
              <p:cNvSpPr/>
              <p:nvPr/>
            </p:nvSpPr>
            <p:spPr>
              <a:xfrm>
                <a:off x="6091791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7" name="Rectangle 96">
                <a:extLst>
                  <a:ext uri="{FF2B5EF4-FFF2-40B4-BE49-F238E27FC236}">
                    <a16:creationId xmlns:a16="http://schemas.microsoft.com/office/drawing/2014/main" id="{98683610-F16C-40DF-A175-7F34B217B41C}"/>
                  </a:ext>
                </a:extLst>
              </p:cNvPr>
              <p:cNvSpPr/>
              <p:nvPr/>
            </p:nvSpPr>
            <p:spPr>
              <a:xfrm>
                <a:off x="564577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8" name="Rectangle 97">
                <a:extLst>
                  <a:ext uri="{FF2B5EF4-FFF2-40B4-BE49-F238E27FC236}">
                    <a16:creationId xmlns:a16="http://schemas.microsoft.com/office/drawing/2014/main" id="{95E0C0D7-D2CE-47F9-9265-5D1365DDE21C}"/>
                  </a:ext>
                </a:extLst>
              </p:cNvPr>
              <p:cNvSpPr/>
              <p:nvPr/>
            </p:nvSpPr>
            <p:spPr>
              <a:xfrm>
                <a:off x="5999858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91A81DE8-12E8-4A60-9897-3118C7272438}"/>
                  </a:ext>
                </a:extLst>
              </p:cNvPr>
              <p:cNvSpPr/>
              <p:nvPr/>
            </p:nvSpPr>
            <p:spPr>
              <a:xfrm>
                <a:off x="644587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Rectangle 99">
                <a:extLst>
                  <a:ext uri="{FF2B5EF4-FFF2-40B4-BE49-F238E27FC236}">
                    <a16:creationId xmlns:a16="http://schemas.microsoft.com/office/drawing/2014/main" id="{667B24FF-C2EA-4A02-8C2C-3A08434470A7}"/>
                  </a:ext>
                </a:extLst>
              </p:cNvPr>
              <p:cNvSpPr/>
              <p:nvPr/>
            </p:nvSpPr>
            <p:spPr>
              <a:xfrm>
                <a:off x="546873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1" name="Rectangle 100">
                <a:extLst>
                  <a:ext uri="{FF2B5EF4-FFF2-40B4-BE49-F238E27FC236}">
                    <a16:creationId xmlns:a16="http://schemas.microsoft.com/office/drawing/2014/main" id="{2880956F-F11E-4718-8A2F-83F9B33729D8}"/>
                  </a:ext>
                </a:extLst>
              </p:cNvPr>
              <p:cNvSpPr/>
              <p:nvPr/>
            </p:nvSpPr>
            <p:spPr>
              <a:xfrm>
                <a:off x="6176900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2" name="Rectangle 101">
                <a:extLst>
                  <a:ext uri="{FF2B5EF4-FFF2-40B4-BE49-F238E27FC236}">
                    <a16:creationId xmlns:a16="http://schemas.microsoft.com/office/drawing/2014/main" id="{7D555809-E7EC-4BAD-B7BD-D1DE75CF431A}"/>
                  </a:ext>
                </a:extLst>
              </p:cNvPr>
              <p:cNvSpPr/>
              <p:nvPr/>
            </p:nvSpPr>
            <p:spPr>
              <a:xfrm>
                <a:off x="6530984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Rectangle 102">
                <a:extLst>
                  <a:ext uri="{FF2B5EF4-FFF2-40B4-BE49-F238E27FC236}">
                    <a16:creationId xmlns:a16="http://schemas.microsoft.com/office/drawing/2014/main" id="{58140FE2-B576-4DD7-B2ED-F25B47B0AE22}"/>
                  </a:ext>
                </a:extLst>
              </p:cNvPr>
              <p:cNvSpPr/>
              <p:nvPr/>
            </p:nvSpPr>
            <p:spPr>
              <a:xfrm>
                <a:off x="6708026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id="{56D9121C-706B-4EFF-AD26-227683EFDACF}"/>
                  </a:ext>
                </a:extLst>
              </p:cNvPr>
              <p:cNvSpPr/>
              <p:nvPr/>
            </p:nvSpPr>
            <p:spPr>
              <a:xfrm>
                <a:off x="6268833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Rectangle 104">
                <a:extLst>
                  <a:ext uri="{FF2B5EF4-FFF2-40B4-BE49-F238E27FC236}">
                    <a16:creationId xmlns:a16="http://schemas.microsoft.com/office/drawing/2014/main" id="{A2AA0264-C7D1-4ACF-A221-282AA2F559EA}"/>
                  </a:ext>
                </a:extLst>
              </p:cNvPr>
              <p:cNvSpPr/>
              <p:nvPr/>
            </p:nvSpPr>
            <p:spPr>
              <a:xfrm>
                <a:off x="6885575" y="1956551"/>
                <a:ext cx="429768" cy="228022"/>
              </a:xfrm>
              <a:prstGeom prst="rect">
                <a:avLst/>
              </a:prstGeom>
              <a:solidFill>
                <a:srgbClr val="0066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2C123B1D-0338-43D4-BC45-69F34A39C846}"/>
                  </a:ext>
                </a:extLst>
              </p:cNvPr>
              <p:cNvSpPr/>
              <p:nvPr/>
            </p:nvSpPr>
            <p:spPr>
              <a:xfrm>
                <a:off x="7323095" y="1956551"/>
                <a:ext cx="54864" cy="228022"/>
              </a:xfrm>
              <a:prstGeom prst="rect">
                <a:avLst/>
              </a:prstGeom>
              <a:solidFill>
                <a:srgbClr val="7030A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B3576BDC-C3F2-4F94-9E02-55386B72BCC6}"/>
                  </a:ext>
                </a:extLst>
              </p:cNvPr>
              <p:cNvSpPr/>
              <p:nvPr/>
            </p:nvSpPr>
            <p:spPr>
              <a:xfrm>
                <a:off x="5914749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1F7A20F3-362B-45B6-99B7-824996B6AC29}"/>
                  </a:ext>
                </a:extLst>
              </p:cNvPr>
              <p:cNvSpPr/>
              <p:nvPr/>
            </p:nvSpPr>
            <p:spPr>
              <a:xfrm>
                <a:off x="5822816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9" name="Rectangle 108">
                <a:extLst>
                  <a:ext uri="{FF2B5EF4-FFF2-40B4-BE49-F238E27FC236}">
                    <a16:creationId xmlns:a16="http://schemas.microsoft.com/office/drawing/2014/main" id="{11DDFB9B-845C-469C-8B0C-983E5CD6E2FE}"/>
                  </a:ext>
                </a:extLst>
              </p:cNvPr>
              <p:cNvSpPr/>
              <p:nvPr/>
            </p:nvSpPr>
            <p:spPr>
              <a:xfrm>
                <a:off x="6353942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D0A22F11-304B-45B9-9CDF-F1917128620A}"/>
                  </a:ext>
                </a:extLst>
              </p:cNvPr>
              <p:cNvSpPr/>
              <p:nvPr/>
            </p:nvSpPr>
            <p:spPr>
              <a:xfrm>
                <a:off x="6799955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1" name="Rectangle 110">
                <a:extLst>
                  <a:ext uri="{FF2B5EF4-FFF2-40B4-BE49-F238E27FC236}">
                    <a16:creationId xmlns:a16="http://schemas.microsoft.com/office/drawing/2014/main" id="{B34DBF0E-4585-4834-9542-E3582A1123CF}"/>
                  </a:ext>
                </a:extLst>
              </p:cNvPr>
              <p:cNvSpPr/>
              <p:nvPr/>
            </p:nvSpPr>
            <p:spPr>
              <a:xfrm>
                <a:off x="527413" y="1956551"/>
                <a:ext cx="36576" cy="2286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4"/>
                  </a:solidFill>
                </a:endParaRPr>
              </a:p>
            </p:txBody>
          </p:sp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9D315F3E-64AF-4B9C-8E62-2D9DFEA212E6}"/>
                  </a:ext>
                </a:extLst>
              </p:cNvPr>
              <p:cNvSpPr/>
              <p:nvPr/>
            </p:nvSpPr>
            <p:spPr>
              <a:xfrm>
                <a:off x="564662" y="1956551"/>
                <a:ext cx="914400" cy="2286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94EF5E3A-26EF-47F2-B653-30947D82AD57}"/>
                  </a:ext>
                </a:extLst>
              </p:cNvPr>
              <p:cNvSpPr/>
              <p:nvPr/>
            </p:nvSpPr>
            <p:spPr>
              <a:xfrm>
                <a:off x="6622917" y="1956551"/>
                <a:ext cx="82296" cy="228022"/>
              </a:xfrm>
              <a:prstGeom prst="rect">
                <a:avLst/>
              </a:prstGeom>
              <a:solidFill>
                <a:srgbClr val="92D05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40" name="Group 139">
              <a:extLst>
                <a:ext uri="{FF2B5EF4-FFF2-40B4-BE49-F238E27FC236}">
                  <a16:creationId xmlns:a16="http://schemas.microsoft.com/office/drawing/2014/main" id="{B8C4411D-C052-4789-BD09-4AD130DE7BEA}"/>
                </a:ext>
              </a:extLst>
            </p:cNvPr>
            <p:cNvGrpSpPr/>
            <p:nvPr/>
          </p:nvGrpSpPr>
          <p:grpSpPr>
            <a:xfrm>
              <a:off x="527413" y="2547092"/>
              <a:ext cx="2528546" cy="228600"/>
              <a:chOff x="527413" y="2585501"/>
              <a:chExt cx="2528546" cy="228600"/>
            </a:xfrm>
          </p:grpSpPr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824E47CC-CB90-4275-94FC-18A57D89BF2E}"/>
                  </a:ext>
                </a:extLst>
              </p:cNvPr>
              <p:cNvSpPr/>
              <p:nvPr/>
            </p:nvSpPr>
            <p:spPr>
              <a:xfrm>
                <a:off x="527413" y="2585501"/>
                <a:ext cx="36576" cy="228600"/>
              </a:xfrm>
              <a:prstGeom prst="rect">
                <a:avLst/>
              </a:prstGeom>
              <a:solidFill>
                <a:srgbClr val="FFC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4"/>
                  </a:solidFill>
                </a:endParaRPr>
              </a:p>
            </p:txBody>
          </p:sp>
          <p:sp>
            <p:nvSpPr>
              <p:cNvPr id="129" name="Rectangle 128">
                <a:extLst>
                  <a:ext uri="{FF2B5EF4-FFF2-40B4-BE49-F238E27FC236}">
                    <a16:creationId xmlns:a16="http://schemas.microsoft.com/office/drawing/2014/main" id="{57130DC9-C168-406B-A671-4A916B5EE5CF}"/>
                  </a:ext>
                </a:extLst>
              </p:cNvPr>
              <p:cNvSpPr/>
              <p:nvPr/>
            </p:nvSpPr>
            <p:spPr>
              <a:xfrm>
                <a:off x="569612" y="2585501"/>
                <a:ext cx="758952" cy="228600"/>
              </a:xfrm>
              <a:prstGeom prst="rect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0" name="Rectangle 129">
                <a:extLst>
                  <a:ext uri="{FF2B5EF4-FFF2-40B4-BE49-F238E27FC236}">
                    <a16:creationId xmlns:a16="http://schemas.microsoft.com/office/drawing/2014/main" id="{D6F8BF60-A1E7-43DB-B7B9-ABA883130456}"/>
                  </a:ext>
                </a:extLst>
              </p:cNvPr>
              <p:cNvSpPr/>
              <p:nvPr/>
            </p:nvSpPr>
            <p:spPr>
              <a:xfrm>
                <a:off x="1333610" y="2585501"/>
                <a:ext cx="1636776" cy="228600"/>
              </a:xfrm>
              <a:prstGeom prst="rect">
                <a:avLst/>
              </a:prstGeom>
              <a:solidFill>
                <a:srgbClr val="3333CC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1" name="Rectangle 130">
                <a:extLst>
                  <a:ext uri="{FF2B5EF4-FFF2-40B4-BE49-F238E27FC236}">
                    <a16:creationId xmlns:a16="http://schemas.microsoft.com/office/drawing/2014/main" id="{87AB9E63-6A40-4ED1-B3AC-0A4639DEBB54}"/>
                  </a:ext>
                </a:extLst>
              </p:cNvPr>
              <p:cNvSpPr/>
              <p:nvPr/>
            </p:nvSpPr>
            <p:spPr>
              <a:xfrm>
                <a:off x="2982807" y="2585501"/>
                <a:ext cx="73152" cy="228600"/>
              </a:xfrm>
              <a:prstGeom prst="rect">
                <a:avLst/>
              </a:prstGeom>
              <a:solidFill>
                <a:srgbClr val="7030A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rgbClr val="7030A0"/>
                  </a:solidFill>
                </a:endParaRPr>
              </a:p>
            </p:txBody>
          </p:sp>
        </p:grp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343FA6CB-8ADA-4EE9-966B-4ED1CF05BED0}"/>
                </a:ext>
              </a:extLst>
            </p:cNvPr>
            <p:cNvSpPr txBox="1"/>
            <p:nvPr/>
          </p:nvSpPr>
          <p:spPr>
            <a:xfrm>
              <a:off x="1118870" y="1129792"/>
              <a:ext cx="391645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hromosome 2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015,371 to 1,021,181 of 2,740,984 total)</a:t>
              </a: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4B9B9B2E-2062-4ED9-B18B-636503BF946B}"/>
                </a:ext>
              </a:extLst>
            </p:cNvPr>
            <p:cNvSpPr txBox="1"/>
            <p:nvPr/>
          </p:nvSpPr>
          <p:spPr>
            <a:xfrm>
              <a:off x="1099210" y="1743867"/>
              <a:ext cx="37240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hromosome 2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314,846 to 306,462 of 2,740,984 total)</a:t>
              </a: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F670EB90-21AF-49E4-BB75-76209CADBF14}"/>
                </a:ext>
              </a:extLst>
            </p:cNvPr>
            <p:cNvSpPr txBox="1"/>
            <p:nvPr/>
          </p:nvSpPr>
          <p:spPr>
            <a:xfrm>
              <a:off x="1145153" y="2337998"/>
              <a:ext cx="391645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chromosome 4;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 1,627,022 to 1,623,864 of 1,803,401 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otal)</a:t>
              </a:r>
            </a:p>
          </p:txBody>
        </p:sp>
      </p:grpSp>
      <p:sp>
        <p:nvSpPr>
          <p:cNvPr id="134" name="TextBox 133">
            <a:extLst>
              <a:ext uri="{FF2B5EF4-FFF2-40B4-BE49-F238E27FC236}">
                <a16:creationId xmlns:a16="http://schemas.microsoft.com/office/drawing/2014/main" id="{68E26761-2CBD-4EBB-8115-94E2B89A7467}"/>
              </a:ext>
            </a:extLst>
          </p:cNvPr>
          <p:cNvSpPr txBox="1"/>
          <p:nvPr/>
        </p:nvSpPr>
        <p:spPr>
          <a:xfrm>
            <a:off x="895317" y="3779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DDD03CFE-9267-475E-B330-CBBA13875216}"/>
              </a:ext>
            </a:extLst>
          </p:cNvPr>
          <p:cNvSpPr txBox="1"/>
          <p:nvPr/>
        </p:nvSpPr>
        <p:spPr>
          <a:xfrm>
            <a:off x="1782010" y="34257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3AC7763E-212E-42C6-B790-68DA6D9E8370}"/>
              </a:ext>
            </a:extLst>
          </p:cNvPr>
          <p:cNvSpPr txBox="1"/>
          <p:nvPr/>
        </p:nvSpPr>
        <p:spPr>
          <a:xfrm>
            <a:off x="1505935" y="51090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80902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3241463-9083-4C78-A9E3-00397E18F34F}"/>
              </a:ext>
            </a:extLst>
          </p:cNvPr>
          <p:cNvSpPr txBox="1"/>
          <p:nvPr/>
        </p:nvSpPr>
        <p:spPr>
          <a:xfrm>
            <a:off x="559606" y="578488"/>
            <a:ext cx="802478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9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|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pit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feature summary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ine drawings to illustrate the basic features of the Als proteins predicted from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pit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sequence and validated by PCR amplification/Sanger sequencing. Genome assembl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M20916v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ordinates were referenced above each drawing. A color-coding key and scale bar are shown. The red region in each drawing corresponded to the NT-Als domain; the “+” designation referred to inclusion of sequences C-terminal to NT-Als (i.e. the red region ends where repeated sequences or Ser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 sequences began)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andemly repeated sequence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Als278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36 amino acids long while some repeat units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sAls238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39-42 amino acids. A consensus was derived from the 36-amino acid units and compared to those from previously characterized sequence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cent identity values for comparisons among the NT-Als sequences for each protein calculat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deira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luded for reference because its crystallographic structure is known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 et al., 201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</p:spTree>
    <p:extLst>
      <p:ext uri="{BB962C8B-B14F-4D97-AF65-F5344CB8AC3E}">
        <p14:creationId xmlns:p14="http://schemas.microsoft.com/office/powerpoint/2010/main" val="3034391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3</TotalTime>
  <Words>403</Words>
  <Application>Microsoft Office PowerPoint</Application>
  <PresentationFormat>On-screen Show (4:3)</PresentationFormat>
  <Paragraphs>4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is Hoyer</dc:creator>
  <cp:lastModifiedBy>Lois Hoyer</cp:lastModifiedBy>
  <cp:revision>1</cp:revision>
  <dcterms:created xsi:type="dcterms:W3CDTF">2021-08-31T18:47:01Z</dcterms:created>
  <dcterms:modified xsi:type="dcterms:W3CDTF">2021-10-03T15:25:13Z</dcterms:modified>
</cp:coreProperties>
</file>